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5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74" autoAdjust="0"/>
    <p:restoredTop sz="94660"/>
  </p:normalViewPr>
  <p:slideViewPr>
    <p:cSldViewPr showGuides="1">
      <p:cViewPr>
        <p:scale>
          <a:sx n="70" d="100"/>
          <a:sy n="70" d="100"/>
        </p:scale>
        <p:origin x="-1589" y="1181"/>
      </p:cViewPr>
      <p:guideLst>
        <p:guide orient="horz" pos="3120"/>
        <p:guide pos="193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037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53335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1153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45395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96914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6019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25488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68766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278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77341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7135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B9AD0F-B56C-463D-B794-DD3CFEDFDB4E}" type="datetimeFigureOut">
              <a:rPr kumimoji="1" lang="ja-JP" altLang="en-US" smtClean="0"/>
              <a:t>201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DA29AA-54FD-4ADF-BE23-598883758E4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5272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テキスト ボックス 20"/>
          <p:cNvSpPr txBox="1"/>
          <p:nvPr/>
        </p:nvSpPr>
        <p:spPr>
          <a:xfrm>
            <a:off x="887574" y="1485962"/>
            <a:ext cx="602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sz="1000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g/ml)</a:t>
            </a:r>
            <a:endParaRPr kumimoji="1"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1614475" y="1375246"/>
            <a:ext cx="641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8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2690077" y="150480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sz="1000" dirty="0" err="1">
                <a:latin typeface="Times New Roman" pitchFamily="18" charset="0"/>
                <a:cs typeface="Times New Roman" pitchFamily="18" charset="0"/>
              </a:rPr>
              <a:t>n</a:t>
            </a:r>
            <a:r>
              <a:rPr kumimoji="1" lang="en-US" altLang="ja-JP" sz="1000" dirty="0" err="1" smtClean="0">
                <a:latin typeface="Times New Roman" pitchFamily="18" charset="0"/>
                <a:cs typeface="Times New Roman" pitchFamily="18" charset="0"/>
              </a:rPr>
              <a:t>g</a:t>
            </a:r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/ml)</a:t>
            </a:r>
            <a:endParaRPr kumimoji="1"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5070739" y="1394991"/>
            <a:ext cx="950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ja-JP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E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4494675" y="150404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sz="1000" dirty="0" err="1">
                <a:latin typeface="Times New Roman" pitchFamily="18" charset="0"/>
                <a:cs typeface="Times New Roman" pitchFamily="18" charset="0"/>
              </a:rPr>
              <a:t>n</a:t>
            </a:r>
            <a:r>
              <a:rPr kumimoji="1" lang="en-US" altLang="ja-JP" sz="1000" dirty="0" err="1" smtClean="0">
                <a:latin typeface="Times New Roman" pitchFamily="18" charset="0"/>
                <a:cs typeface="Times New Roman" pitchFamily="18" charset="0"/>
              </a:rPr>
              <a:t>g</a:t>
            </a:r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/ml)</a:t>
            </a:r>
            <a:endParaRPr kumimoji="1"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414555" y="1394230"/>
            <a:ext cx="590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CP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73" name="グループ化 72"/>
          <p:cNvGrpSpPr/>
          <p:nvPr/>
        </p:nvGrpSpPr>
        <p:grpSpPr>
          <a:xfrm>
            <a:off x="4925950" y="1796364"/>
            <a:ext cx="1080000" cy="1800000"/>
            <a:chOff x="4873625" y="5618163"/>
            <a:chExt cx="1498600" cy="2155825"/>
          </a:xfrm>
        </p:grpSpPr>
        <p:sp>
          <p:nvSpPr>
            <p:cNvPr id="8" name="Freeform 6"/>
            <p:cNvSpPr>
              <a:spLocks noEditPoints="1"/>
            </p:cNvSpPr>
            <p:nvPr/>
          </p:nvSpPr>
          <p:spPr bwMode="auto">
            <a:xfrm>
              <a:off x="4873625" y="5618163"/>
              <a:ext cx="1498600" cy="2155825"/>
            </a:xfrm>
            <a:custGeom>
              <a:avLst/>
              <a:gdLst>
                <a:gd name="T0" fmla="*/ 0 w 1887"/>
                <a:gd name="T1" fmla="*/ 6 h 2714"/>
                <a:gd name="T2" fmla="*/ 0 w 1887"/>
                <a:gd name="T3" fmla="*/ 0 h 2714"/>
                <a:gd name="T4" fmla="*/ 6 w 1887"/>
                <a:gd name="T5" fmla="*/ 0 h 2714"/>
                <a:gd name="T6" fmla="*/ 1881 w 1887"/>
                <a:gd name="T7" fmla="*/ 0 h 2714"/>
                <a:gd name="T8" fmla="*/ 1885 w 1887"/>
                <a:gd name="T9" fmla="*/ 0 h 2714"/>
                <a:gd name="T10" fmla="*/ 1887 w 1887"/>
                <a:gd name="T11" fmla="*/ 6 h 2714"/>
                <a:gd name="T12" fmla="*/ 1887 w 1887"/>
                <a:gd name="T13" fmla="*/ 2708 h 2714"/>
                <a:gd name="T14" fmla="*/ 1885 w 1887"/>
                <a:gd name="T15" fmla="*/ 2712 h 2714"/>
                <a:gd name="T16" fmla="*/ 1881 w 1887"/>
                <a:gd name="T17" fmla="*/ 2714 h 2714"/>
                <a:gd name="T18" fmla="*/ 6 w 1887"/>
                <a:gd name="T19" fmla="*/ 2714 h 2714"/>
                <a:gd name="T20" fmla="*/ 0 w 1887"/>
                <a:gd name="T21" fmla="*/ 2712 h 2714"/>
                <a:gd name="T22" fmla="*/ 0 w 1887"/>
                <a:gd name="T23" fmla="*/ 2708 h 2714"/>
                <a:gd name="T24" fmla="*/ 0 w 1887"/>
                <a:gd name="T25" fmla="*/ 6 h 2714"/>
                <a:gd name="T26" fmla="*/ 12 w 1887"/>
                <a:gd name="T27" fmla="*/ 2708 h 2714"/>
                <a:gd name="T28" fmla="*/ 6 w 1887"/>
                <a:gd name="T29" fmla="*/ 2703 h 2714"/>
                <a:gd name="T30" fmla="*/ 1881 w 1887"/>
                <a:gd name="T31" fmla="*/ 2703 h 2714"/>
                <a:gd name="T32" fmla="*/ 1876 w 1887"/>
                <a:gd name="T33" fmla="*/ 2708 h 2714"/>
                <a:gd name="T34" fmla="*/ 1876 w 1887"/>
                <a:gd name="T35" fmla="*/ 6 h 2714"/>
                <a:gd name="T36" fmla="*/ 1881 w 1887"/>
                <a:gd name="T37" fmla="*/ 11 h 2714"/>
                <a:gd name="T38" fmla="*/ 6 w 1887"/>
                <a:gd name="T39" fmla="*/ 11 h 2714"/>
                <a:gd name="T40" fmla="*/ 12 w 1887"/>
                <a:gd name="T41" fmla="*/ 6 h 2714"/>
                <a:gd name="T42" fmla="*/ 12 w 1887"/>
                <a:gd name="T43" fmla="*/ 2708 h 27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887" h="2714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881" y="0"/>
                  </a:lnTo>
                  <a:lnTo>
                    <a:pt x="1885" y="0"/>
                  </a:lnTo>
                  <a:lnTo>
                    <a:pt x="1887" y="6"/>
                  </a:lnTo>
                  <a:lnTo>
                    <a:pt x="1887" y="2708"/>
                  </a:lnTo>
                  <a:lnTo>
                    <a:pt x="1885" y="2712"/>
                  </a:lnTo>
                  <a:lnTo>
                    <a:pt x="1881" y="2714"/>
                  </a:lnTo>
                  <a:lnTo>
                    <a:pt x="6" y="2714"/>
                  </a:lnTo>
                  <a:lnTo>
                    <a:pt x="0" y="2712"/>
                  </a:lnTo>
                  <a:lnTo>
                    <a:pt x="0" y="2708"/>
                  </a:lnTo>
                  <a:lnTo>
                    <a:pt x="0" y="6"/>
                  </a:lnTo>
                  <a:close/>
                  <a:moveTo>
                    <a:pt x="12" y="2708"/>
                  </a:moveTo>
                  <a:lnTo>
                    <a:pt x="6" y="2703"/>
                  </a:lnTo>
                  <a:lnTo>
                    <a:pt x="1881" y="2703"/>
                  </a:lnTo>
                  <a:lnTo>
                    <a:pt x="1876" y="2708"/>
                  </a:lnTo>
                  <a:lnTo>
                    <a:pt x="1876" y="6"/>
                  </a:lnTo>
                  <a:lnTo>
                    <a:pt x="1881" y="11"/>
                  </a:lnTo>
                  <a:lnTo>
                    <a:pt x="6" y="11"/>
                  </a:lnTo>
                  <a:lnTo>
                    <a:pt x="12" y="6"/>
                  </a:lnTo>
                  <a:lnTo>
                    <a:pt x="12" y="2708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9" name="Freeform 7"/>
            <p:cNvSpPr>
              <a:spLocks noEditPoints="1"/>
            </p:cNvSpPr>
            <p:nvPr/>
          </p:nvSpPr>
          <p:spPr bwMode="auto">
            <a:xfrm>
              <a:off x="5022850" y="5880100"/>
              <a:ext cx="207962" cy="1893887"/>
            </a:xfrm>
            <a:custGeom>
              <a:avLst/>
              <a:gdLst>
                <a:gd name="T0" fmla="*/ 0 w 261"/>
                <a:gd name="T1" fmla="*/ 6 h 2386"/>
                <a:gd name="T2" fmla="*/ 0 w 261"/>
                <a:gd name="T3" fmla="*/ 0 h 2386"/>
                <a:gd name="T4" fmla="*/ 6 w 261"/>
                <a:gd name="T5" fmla="*/ 0 h 2386"/>
                <a:gd name="T6" fmla="*/ 256 w 261"/>
                <a:gd name="T7" fmla="*/ 0 h 2386"/>
                <a:gd name="T8" fmla="*/ 259 w 261"/>
                <a:gd name="T9" fmla="*/ 0 h 2386"/>
                <a:gd name="T10" fmla="*/ 261 w 261"/>
                <a:gd name="T11" fmla="*/ 6 h 2386"/>
                <a:gd name="T12" fmla="*/ 261 w 261"/>
                <a:gd name="T13" fmla="*/ 2380 h 2386"/>
                <a:gd name="T14" fmla="*/ 259 w 261"/>
                <a:gd name="T15" fmla="*/ 2384 h 2386"/>
                <a:gd name="T16" fmla="*/ 256 w 261"/>
                <a:gd name="T17" fmla="*/ 2386 h 2386"/>
                <a:gd name="T18" fmla="*/ 6 w 261"/>
                <a:gd name="T19" fmla="*/ 2386 h 2386"/>
                <a:gd name="T20" fmla="*/ 0 w 261"/>
                <a:gd name="T21" fmla="*/ 2384 h 2386"/>
                <a:gd name="T22" fmla="*/ 0 w 261"/>
                <a:gd name="T23" fmla="*/ 2380 h 2386"/>
                <a:gd name="T24" fmla="*/ 0 w 261"/>
                <a:gd name="T25" fmla="*/ 6 h 2386"/>
                <a:gd name="T26" fmla="*/ 12 w 261"/>
                <a:gd name="T27" fmla="*/ 2380 h 2386"/>
                <a:gd name="T28" fmla="*/ 6 w 261"/>
                <a:gd name="T29" fmla="*/ 2375 h 2386"/>
                <a:gd name="T30" fmla="*/ 256 w 261"/>
                <a:gd name="T31" fmla="*/ 2375 h 2386"/>
                <a:gd name="T32" fmla="*/ 250 w 261"/>
                <a:gd name="T33" fmla="*/ 2380 h 2386"/>
                <a:gd name="T34" fmla="*/ 250 w 261"/>
                <a:gd name="T35" fmla="*/ 6 h 2386"/>
                <a:gd name="T36" fmla="*/ 256 w 261"/>
                <a:gd name="T37" fmla="*/ 12 h 2386"/>
                <a:gd name="T38" fmla="*/ 6 w 261"/>
                <a:gd name="T39" fmla="*/ 12 h 2386"/>
                <a:gd name="T40" fmla="*/ 12 w 261"/>
                <a:gd name="T41" fmla="*/ 6 h 2386"/>
                <a:gd name="T42" fmla="*/ 12 w 261"/>
                <a:gd name="T43" fmla="*/ 2380 h 23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61" h="2386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256" y="0"/>
                  </a:lnTo>
                  <a:lnTo>
                    <a:pt x="259" y="0"/>
                  </a:lnTo>
                  <a:lnTo>
                    <a:pt x="261" y="6"/>
                  </a:lnTo>
                  <a:lnTo>
                    <a:pt x="261" y="2380"/>
                  </a:lnTo>
                  <a:lnTo>
                    <a:pt x="259" y="2384"/>
                  </a:lnTo>
                  <a:lnTo>
                    <a:pt x="256" y="2386"/>
                  </a:lnTo>
                  <a:lnTo>
                    <a:pt x="6" y="2386"/>
                  </a:lnTo>
                  <a:lnTo>
                    <a:pt x="0" y="2384"/>
                  </a:lnTo>
                  <a:lnTo>
                    <a:pt x="0" y="2380"/>
                  </a:lnTo>
                  <a:lnTo>
                    <a:pt x="0" y="6"/>
                  </a:lnTo>
                  <a:close/>
                  <a:moveTo>
                    <a:pt x="12" y="2380"/>
                  </a:moveTo>
                  <a:lnTo>
                    <a:pt x="6" y="2375"/>
                  </a:lnTo>
                  <a:lnTo>
                    <a:pt x="256" y="2375"/>
                  </a:lnTo>
                  <a:lnTo>
                    <a:pt x="250" y="2380"/>
                  </a:lnTo>
                  <a:lnTo>
                    <a:pt x="250" y="6"/>
                  </a:lnTo>
                  <a:lnTo>
                    <a:pt x="256" y="12"/>
                  </a:lnTo>
                  <a:lnTo>
                    <a:pt x="6" y="12"/>
                  </a:lnTo>
                  <a:lnTo>
                    <a:pt x="12" y="6"/>
                  </a:lnTo>
                  <a:lnTo>
                    <a:pt x="12" y="238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8" name="Freeform 8"/>
            <p:cNvSpPr>
              <a:spLocks noEditPoints="1"/>
            </p:cNvSpPr>
            <p:nvPr/>
          </p:nvSpPr>
          <p:spPr bwMode="auto">
            <a:xfrm>
              <a:off x="5519738" y="7718425"/>
              <a:ext cx="207962" cy="55562"/>
            </a:xfrm>
            <a:custGeom>
              <a:avLst/>
              <a:gdLst>
                <a:gd name="T0" fmla="*/ 0 w 261"/>
                <a:gd name="T1" fmla="*/ 6 h 69"/>
                <a:gd name="T2" fmla="*/ 0 w 261"/>
                <a:gd name="T3" fmla="*/ 0 h 69"/>
                <a:gd name="T4" fmla="*/ 6 w 261"/>
                <a:gd name="T5" fmla="*/ 0 h 69"/>
                <a:gd name="T6" fmla="*/ 255 w 261"/>
                <a:gd name="T7" fmla="*/ 0 h 69"/>
                <a:gd name="T8" fmla="*/ 259 w 261"/>
                <a:gd name="T9" fmla="*/ 0 h 69"/>
                <a:gd name="T10" fmla="*/ 261 w 261"/>
                <a:gd name="T11" fmla="*/ 6 h 69"/>
                <a:gd name="T12" fmla="*/ 261 w 261"/>
                <a:gd name="T13" fmla="*/ 63 h 69"/>
                <a:gd name="T14" fmla="*/ 259 w 261"/>
                <a:gd name="T15" fmla="*/ 67 h 69"/>
                <a:gd name="T16" fmla="*/ 255 w 261"/>
                <a:gd name="T17" fmla="*/ 69 h 69"/>
                <a:gd name="T18" fmla="*/ 6 w 261"/>
                <a:gd name="T19" fmla="*/ 69 h 69"/>
                <a:gd name="T20" fmla="*/ 0 w 261"/>
                <a:gd name="T21" fmla="*/ 67 h 69"/>
                <a:gd name="T22" fmla="*/ 0 w 261"/>
                <a:gd name="T23" fmla="*/ 63 h 69"/>
                <a:gd name="T24" fmla="*/ 0 w 261"/>
                <a:gd name="T25" fmla="*/ 6 h 69"/>
                <a:gd name="T26" fmla="*/ 12 w 261"/>
                <a:gd name="T27" fmla="*/ 63 h 69"/>
                <a:gd name="T28" fmla="*/ 6 w 261"/>
                <a:gd name="T29" fmla="*/ 58 h 69"/>
                <a:gd name="T30" fmla="*/ 255 w 261"/>
                <a:gd name="T31" fmla="*/ 58 h 69"/>
                <a:gd name="T32" fmla="*/ 250 w 261"/>
                <a:gd name="T33" fmla="*/ 63 h 69"/>
                <a:gd name="T34" fmla="*/ 250 w 261"/>
                <a:gd name="T35" fmla="*/ 6 h 69"/>
                <a:gd name="T36" fmla="*/ 255 w 261"/>
                <a:gd name="T37" fmla="*/ 12 h 69"/>
                <a:gd name="T38" fmla="*/ 6 w 261"/>
                <a:gd name="T39" fmla="*/ 12 h 69"/>
                <a:gd name="T40" fmla="*/ 12 w 261"/>
                <a:gd name="T41" fmla="*/ 6 h 69"/>
                <a:gd name="T42" fmla="*/ 12 w 261"/>
                <a:gd name="T43" fmla="*/ 63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61" h="69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255" y="0"/>
                  </a:lnTo>
                  <a:lnTo>
                    <a:pt x="259" y="0"/>
                  </a:lnTo>
                  <a:lnTo>
                    <a:pt x="261" y="6"/>
                  </a:lnTo>
                  <a:lnTo>
                    <a:pt x="261" y="63"/>
                  </a:lnTo>
                  <a:lnTo>
                    <a:pt x="259" y="67"/>
                  </a:lnTo>
                  <a:lnTo>
                    <a:pt x="255" y="69"/>
                  </a:lnTo>
                  <a:lnTo>
                    <a:pt x="6" y="69"/>
                  </a:lnTo>
                  <a:lnTo>
                    <a:pt x="0" y="67"/>
                  </a:lnTo>
                  <a:lnTo>
                    <a:pt x="0" y="63"/>
                  </a:lnTo>
                  <a:lnTo>
                    <a:pt x="0" y="6"/>
                  </a:lnTo>
                  <a:close/>
                  <a:moveTo>
                    <a:pt x="12" y="63"/>
                  </a:moveTo>
                  <a:lnTo>
                    <a:pt x="6" y="58"/>
                  </a:lnTo>
                  <a:lnTo>
                    <a:pt x="255" y="58"/>
                  </a:lnTo>
                  <a:lnTo>
                    <a:pt x="250" y="63"/>
                  </a:lnTo>
                  <a:lnTo>
                    <a:pt x="250" y="6"/>
                  </a:lnTo>
                  <a:lnTo>
                    <a:pt x="255" y="12"/>
                  </a:lnTo>
                  <a:lnTo>
                    <a:pt x="6" y="12"/>
                  </a:lnTo>
                  <a:lnTo>
                    <a:pt x="12" y="6"/>
                  </a:lnTo>
                  <a:lnTo>
                    <a:pt x="12" y="63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9" name="Freeform 9"/>
            <p:cNvSpPr>
              <a:spLocks noEditPoints="1"/>
            </p:cNvSpPr>
            <p:nvPr/>
          </p:nvSpPr>
          <p:spPr bwMode="auto">
            <a:xfrm>
              <a:off x="6015038" y="7732713"/>
              <a:ext cx="206375" cy="41275"/>
            </a:xfrm>
            <a:custGeom>
              <a:avLst/>
              <a:gdLst>
                <a:gd name="T0" fmla="*/ 0 w 261"/>
                <a:gd name="T1" fmla="*/ 6 h 52"/>
                <a:gd name="T2" fmla="*/ 0 w 261"/>
                <a:gd name="T3" fmla="*/ 0 h 52"/>
                <a:gd name="T4" fmla="*/ 6 w 261"/>
                <a:gd name="T5" fmla="*/ 0 h 52"/>
                <a:gd name="T6" fmla="*/ 255 w 261"/>
                <a:gd name="T7" fmla="*/ 0 h 52"/>
                <a:gd name="T8" fmla="*/ 259 w 261"/>
                <a:gd name="T9" fmla="*/ 0 h 52"/>
                <a:gd name="T10" fmla="*/ 261 w 261"/>
                <a:gd name="T11" fmla="*/ 6 h 52"/>
                <a:gd name="T12" fmla="*/ 261 w 261"/>
                <a:gd name="T13" fmla="*/ 46 h 52"/>
                <a:gd name="T14" fmla="*/ 259 w 261"/>
                <a:gd name="T15" fmla="*/ 50 h 52"/>
                <a:gd name="T16" fmla="*/ 255 w 261"/>
                <a:gd name="T17" fmla="*/ 52 h 52"/>
                <a:gd name="T18" fmla="*/ 6 w 261"/>
                <a:gd name="T19" fmla="*/ 52 h 52"/>
                <a:gd name="T20" fmla="*/ 0 w 261"/>
                <a:gd name="T21" fmla="*/ 50 h 52"/>
                <a:gd name="T22" fmla="*/ 0 w 261"/>
                <a:gd name="T23" fmla="*/ 46 h 52"/>
                <a:gd name="T24" fmla="*/ 0 w 261"/>
                <a:gd name="T25" fmla="*/ 6 h 52"/>
                <a:gd name="T26" fmla="*/ 11 w 261"/>
                <a:gd name="T27" fmla="*/ 46 h 52"/>
                <a:gd name="T28" fmla="*/ 6 w 261"/>
                <a:gd name="T29" fmla="*/ 41 h 52"/>
                <a:gd name="T30" fmla="*/ 255 w 261"/>
                <a:gd name="T31" fmla="*/ 41 h 52"/>
                <a:gd name="T32" fmla="*/ 249 w 261"/>
                <a:gd name="T33" fmla="*/ 46 h 52"/>
                <a:gd name="T34" fmla="*/ 249 w 261"/>
                <a:gd name="T35" fmla="*/ 6 h 52"/>
                <a:gd name="T36" fmla="*/ 255 w 261"/>
                <a:gd name="T37" fmla="*/ 12 h 52"/>
                <a:gd name="T38" fmla="*/ 6 w 261"/>
                <a:gd name="T39" fmla="*/ 12 h 52"/>
                <a:gd name="T40" fmla="*/ 11 w 261"/>
                <a:gd name="T41" fmla="*/ 6 h 52"/>
                <a:gd name="T42" fmla="*/ 11 w 261"/>
                <a:gd name="T43" fmla="*/ 46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61" h="52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255" y="0"/>
                  </a:lnTo>
                  <a:lnTo>
                    <a:pt x="259" y="0"/>
                  </a:lnTo>
                  <a:lnTo>
                    <a:pt x="261" y="6"/>
                  </a:lnTo>
                  <a:lnTo>
                    <a:pt x="261" y="46"/>
                  </a:lnTo>
                  <a:lnTo>
                    <a:pt x="259" y="50"/>
                  </a:lnTo>
                  <a:lnTo>
                    <a:pt x="255" y="52"/>
                  </a:lnTo>
                  <a:lnTo>
                    <a:pt x="6" y="52"/>
                  </a:lnTo>
                  <a:lnTo>
                    <a:pt x="0" y="50"/>
                  </a:lnTo>
                  <a:lnTo>
                    <a:pt x="0" y="46"/>
                  </a:lnTo>
                  <a:lnTo>
                    <a:pt x="0" y="6"/>
                  </a:lnTo>
                  <a:close/>
                  <a:moveTo>
                    <a:pt x="11" y="46"/>
                  </a:moveTo>
                  <a:lnTo>
                    <a:pt x="6" y="41"/>
                  </a:lnTo>
                  <a:lnTo>
                    <a:pt x="255" y="41"/>
                  </a:lnTo>
                  <a:lnTo>
                    <a:pt x="249" y="46"/>
                  </a:lnTo>
                  <a:lnTo>
                    <a:pt x="249" y="6"/>
                  </a:lnTo>
                  <a:lnTo>
                    <a:pt x="255" y="12"/>
                  </a:lnTo>
                  <a:lnTo>
                    <a:pt x="6" y="12"/>
                  </a:lnTo>
                  <a:lnTo>
                    <a:pt x="11" y="6"/>
                  </a:lnTo>
                  <a:lnTo>
                    <a:pt x="11" y="46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64" name="Rectangle 10"/>
            <p:cNvSpPr>
              <a:spLocks noChangeArrowheads="1"/>
            </p:cNvSpPr>
            <p:nvPr/>
          </p:nvSpPr>
          <p:spPr bwMode="auto">
            <a:xfrm>
              <a:off x="4873625" y="5622925"/>
              <a:ext cx="9525" cy="2146300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74" name="グループ化 73"/>
          <p:cNvGrpSpPr/>
          <p:nvPr/>
        </p:nvGrpSpPr>
        <p:grpSpPr>
          <a:xfrm>
            <a:off x="4616753" y="1751026"/>
            <a:ext cx="256480" cy="1937271"/>
            <a:chOff x="4505053" y="5537200"/>
            <a:chExt cx="256480" cy="1937271"/>
          </a:xfrm>
        </p:grpSpPr>
        <p:sp>
          <p:nvSpPr>
            <p:cNvPr id="67" name="Rectangle 12"/>
            <p:cNvSpPr>
              <a:spLocks noChangeArrowheads="1"/>
            </p:cNvSpPr>
            <p:nvPr/>
          </p:nvSpPr>
          <p:spPr bwMode="auto">
            <a:xfrm>
              <a:off x="4697413" y="732058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13"/>
            <p:cNvSpPr>
              <a:spLocks noChangeArrowheads="1"/>
            </p:cNvSpPr>
            <p:nvPr/>
          </p:nvSpPr>
          <p:spPr bwMode="auto">
            <a:xfrm>
              <a:off x="4505053" y="6963908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Rectangle 14"/>
            <p:cNvSpPr>
              <a:spLocks noChangeArrowheads="1"/>
            </p:cNvSpPr>
            <p:nvPr/>
          </p:nvSpPr>
          <p:spPr bwMode="auto">
            <a:xfrm>
              <a:off x="4505053" y="6607231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Rectangle 15"/>
            <p:cNvSpPr>
              <a:spLocks noChangeArrowheads="1"/>
            </p:cNvSpPr>
            <p:nvPr/>
          </p:nvSpPr>
          <p:spPr bwMode="auto">
            <a:xfrm>
              <a:off x="4505053" y="6250554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16"/>
            <p:cNvSpPr>
              <a:spLocks noChangeArrowheads="1"/>
            </p:cNvSpPr>
            <p:nvPr/>
          </p:nvSpPr>
          <p:spPr bwMode="auto">
            <a:xfrm>
              <a:off x="4505053" y="5893877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Rectangle 17"/>
            <p:cNvSpPr>
              <a:spLocks noChangeArrowheads="1"/>
            </p:cNvSpPr>
            <p:nvPr/>
          </p:nvSpPr>
          <p:spPr bwMode="auto">
            <a:xfrm>
              <a:off x="4505053" y="5537200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5" name="グループ化 74"/>
          <p:cNvGrpSpPr/>
          <p:nvPr/>
        </p:nvGrpSpPr>
        <p:grpSpPr>
          <a:xfrm>
            <a:off x="5039192" y="3646984"/>
            <a:ext cx="878189" cy="153888"/>
            <a:chOff x="1339873" y="2793521"/>
            <a:chExt cx="878189" cy="153888"/>
          </a:xfrm>
        </p:grpSpPr>
        <p:sp>
          <p:nvSpPr>
            <p:cNvPr id="76" name="Rectangle 21"/>
            <p:cNvSpPr>
              <a:spLocks noChangeArrowheads="1"/>
            </p:cNvSpPr>
            <p:nvPr/>
          </p:nvSpPr>
          <p:spPr bwMode="auto">
            <a:xfrm>
              <a:off x="1339873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22"/>
            <p:cNvSpPr>
              <a:spLocks noChangeArrowheads="1"/>
            </p:cNvSpPr>
            <p:nvPr/>
          </p:nvSpPr>
          <p:spPr bwMode="auto">
            <a:xfrm>
              <a:off x="170092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23"/>
            <p:cNvSpPr>
              <a:spLocks noChangeArrowheads="1"/>
            </p:cNvSpPr>
            <p:nvPr/>
          </p:nvSpPr>
          <p:spPr bwMode="auto">
            <a:xfrm>
              <a:off x="206096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91" name="テキスト ボックス 90"/>
          <p:cNvSpPr txBox="1"/>
          <p:nvPr/>
        </p:nvSpPr>
        <p:spPr>
          <a:xfrm rot="16200000">
            <a:off x="233325" y="2354414"/>
            <a:ext cx="9077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ight eye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35" name="グループ化 1034"/>
          <p:cNvGrpSpPr/>
          <p:nvPr/>
        </p:nvGrpSpPr>
        <p:grpSpPr>
          <a:xfrm>
            <a:off x="1329013" y="1808238"/>
            <a:ext cx="1080000" cy="1800000"/>
            <a:chOff x="831850" y="5594350"/>
            <a:chExt cx="1427163" cy="2413001"/>
          </a:xfrm>
        </p:grpSpPr>
        <p:sp>
          <p:nvSpPr>
            <p:cNvPr id="95" name="Freeform 22"/>
            <p:cNvSpPr>
              <a:spLocks noEditPoints="1"/>
            </p:cNvSpPr>
            <p:nvPr/>
          </p:nvSpPr>
          <p:spPr bwMode="auto">
            <a:xfrm>
              <a:off x="831850" y="5594350"/>
              <a:ext cx="1427163" cy="2413000"/>
            </a:xfrm>
            <a:custGeom>
              <a:avLst/>
              <a:gdLst>
                <a:gd name="T0" fmla="*/ 0 w 1796"/>
                <a:gd name="T1" fmla="*/ 6 h 3040"/>
                <a:gd name="T2" fmla="*/ 0 w 1796"/>
                <a:gd name="T3" fmla="*/ 0 h 3040"/>
                <a:gd name="T4" fmla="*/ 6 w 1796"/>
                <a:gd name="T5" fmla="*/ 0 h 3040"/>
                <a:gd name="T6" fmla="*/ 1790 w 1796"/>
                <a:gd name="T7" fmla="*/ 0 h 3040"/>
                <a:gd name="T8" fmla="*/ 1794 w 1796"/>
                <a:gd name="T9" fmla="*/ 0 h 3040"/>
                <a:gd name="T10" fmla="*/ 1796 w 1796"/>
                <a:gd name="T11" fmla="*/ 6 h 3040"/>
                <a:gd name="T12" fmla="*/ 1796 w 1796"/>
                <a:gd name="T13" fmla="*/ 3034 h 3040"/>
                <a:gd name="T14" fmla="*/ 1794 w 1796"/>
                <a:gd name="T15" fmla="*/ 3038 h 3040"/>
                <a:gd name="T16" fmla="*/ 1790 w 1796"/>
                <a:gd name="T17" fmla="*/ 3040 h 3040"/>
                <a:gd name="T18" fmla="*/ 6 w 1796"/>
                <a:gd name="T19" fmla="*/ 3040 h 3040"/>
                <a:gd name="T20" fmla="*/ 0 w 1796"/>
                <a:gd name="T21" fmla="*/ 3038 h 3040"/>
                <a:gd name="T22" fmla="*/ 0 w 1796"/>
                <a:gd name="T23" fmla="*/ 3034 h 3040"/>
                <a:gd name="T24" fmla="*/ 0 w 1796"/>
                <a:gd name="T25" fmla="*/ 6 h 3040"/>
                <a:gd name="T26" fmla="*/ 11 w 1796"/>
                <a:gd name="T27" fmla="*/ 3034 h 3040"/>
                <a:gd name="T28" fmla="*/ 6 w 1796"/>
                <a:gd name="T29" fmla="*/ 3028 h 3040"/>
                <a:gd name="T30" fmla="*/ 1790 w 1796"/>
                <a:gd name="T31" fmla="*/ 3028 h 3040"/>
                <a:gd name="T32" fmla="*/ 1785 w 1796"/>
                <a:gd name="T33" fmla="*/ 3034 h 3040"/>
                <a:gd name="T34" fmla="*/ 1785 w 1796"/>
                <a:gd name="T35" fmla="*/ 6 h 3040"/>
                <a:gd name="T36" fmla="*/ 1790 w 1796"/>
                <a:gd name="T37" fmla="*/ 11 h 3040"/>
                <a:gd name="T38" fmla="*/ 6 w 1796"/>
                <a:gd name="T39" fmla="*/ 11 h 3040"/>
                <a:gd name="T40" fmla="*/ 11 w 1796"/>
                <a:gd name="T41" fmla="*/ 6 h 3040"/>
                <a:gd name="T42" fmla="*/ 11 w 1796"/>
                <a:gd name="T43" fmla="*/ 3034 h 30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796" h="3040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790" y="0"/>
                  </a:lnTo>
                  <a:lnTo>
                    <a:pt x="1794" y="0"/>
                  </a:lnTo>
                  <a:lnTo>
                    <a:pt x="1796" y="6"/>
                  </a:lnTo>
                  <a:lnTo>
                    <a:pt x="1796" y="3034"/>
                  </a:lnTo>
                  <a:lnTo>
                    <a:pt x="1794" y="3038"/>
                  </a:lnTo>
                  <a:lnTo>
                    <a:pt x="1790" y="3040"/>
                  </a:lnTo>
                  <a:lnTo>
                    <a:pt x="6" y="3040"/>
                  </a:lnTo>
                  <a:lnTo>
                    <a:pt x="0" y="3038"/>
                  </a:lnTo>
                  <a:lnTo>
                    <a:pt x="0" y="3034"/>
                  </a:lnTo>
                  <a:lnTo>
                    <a:pt x="0" y="6"/>
                  </a:lnTo>
                  <a:close/>
                  <a:moveTo>
                    <a:pt x="11" y="3034"/>
                  </a:moveTo>
                  <a:lnTo>
                    <a:pt x="6" y="3028"/>
                  </a:lnTo>
                  <a:lnTo>
                    <a:pt x="1790" y="3028"/>
                  </a:lnTo>
                  <a:lnTo>
                    <a:pt x="1785" y="3034"/>
                  </a:lnTo>
                  <a:lnTo>
                    <a:pt x="1785" y="6"/>
                  </a:lnTo>
                  <a:lnTo>
                    <a:pt x="1790" y="11"/>
                  </a:lnTo>
                  <a:lnTo>
                    <a:pt x="6" y="11"/>
                  </a:lnTo>
                  <a:lnTo>
                    <a:pt x="11" y="6"/>
                  </a:lnTo>
                  <a:lnTo>
                    <a:pt x="11" y="3034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4" name="Freeform 23"/>
            <p:cNvSpPr>
              <a:spLocks noEditPoints="1"/>
            </p:cNvSpPr>
            <p:nvPr/>
          </p:nvSpPr>
          <p:spPr bwMode="auto">
            <a:xfrm>
              <a:off x="974725" y="5834063"/>
              <a:ext cx="196850" cy="2173288"/>
            </a:xfrm>
            <a:custGeom>
              <a:avLst/>
              <a:gdLst>
                <a:gd name="T0" fmla="*/ 0 w 250"/>
                <a:gd name="T1" fmla="*/ 6 h 2739"/>
                <a:gd name="T2" fmla="*/ 0 w 250"/>
                <a:gd name="T3" fmla="*/ 0 h 2739"/>
                <a:gd name="T4" fmla="*/ 6 w 250"/>
                <a:gd name="T5" fmla="*/ 0 h 2739"/>
                <a:gd name="T6" fmla="*/ 244 w 250"/>
                <a:gd name="T7" fmla="*/ 0 h 2739"/>
                <a:gd name="T8" fmla="*/ 248 w 250"/>
                <a:gd name="T9" fmla="*/ 0 h 2739"/>
                <a:gd name="T10" fmla="*/ 250 w 250"/>
                <a:gd name="T11" fmla="*/ 6 h 2739"/>
                <a:gd name="T12" fmla="*/ 250 w 250"/>
                <a:gd name="T13" fmla="*/ 2733 h 2739"/>
                <a:gd name="T14" fmla="*/ 248 w 250"/>
                <a:gd name="T15" fmla="*/ 2737 h 2739"/>
                <a:gd name="T16" fmla="*/ 244 w 250"/>
                <a:gd name="T17" fmla="*/ 2739 h 2739"/>
                <a:gd name="T18" fmla="*/ 6 w 250"/>
                <a:gd name="T19" fmla="*/ 2739 h 2739"/>
                <a:gd name="T20" fmla="*/ 0 w 250"/>
                <a:gd name="T21" fmla="*/ 2737 h 2739"/>
                <a:gd name="T22" fmla="*/ 0 w 250"/>
                <a:gd name="T23" fmla="*/ 2733 h 2739"/>
                <a:gd name="T24" fmla="*/ 0 w 250"/>
                <a:gd name="T25" fmla="*/ 6 h 2739"/>
                <a:gd name="T26" fmla="*/ 12 w 250"/>
                <a:gd name="T27" fmla="*/ 2733 h 2739"/>
                <a:gd name="T28" fmla="*/ 6 w 250"/>
                <a:gd name="T29" fmla="*/ 2727 h 2739"/>
                <a:gd name="T30" fmla="*/ 244 w 250"/>
                <a:gd name="T31" fmla="*/ 2727 h 2739"/>
                <a:gd name="T32" fmla="*/ 238 w 250"/>
                <a:gd name="T33" fmla="*/ 2733 h 2739"/>
                <a:gd name="T34" fmla="*/ 238 w 250"/>
                <a:gd name="T35" fmla="*/ 6 h 2739"/>
                <a:gd name="T36" fmla="*/ 244 w 250"/>
                <a:gd name="T37" fmla="*/ 12 h 2739"/>
                <a:gd name="T38" fmla="*/ 6 w 250"/>
                <a:gd name="T39" fmla="*/ 12 h 2739"/>
                <a:gd name="T40" fmla="*/ 12 w 250"/>
                <a:gd name="T41" fmla="*/ 6 h 2739"/>
                <a:gd name="T42" fmla="*/ 12 w 250"/>
                <a:gd name="T43" fmla="*/ 2733 h 27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50" h="2739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244" y="0"/>
                  </a:lnTo>
                  <a:lnTo>
                    <a:pt x="248" y="0"/>
                  </a:lnTo>
                  <a:lnTo>
                    <a:pt x="250" y="6"/>
                  </a:lnTo>
                  <a:lnTo>
                    <a:pt x="250" y="2733"/>
                  </a:lnTo>
                  <a:lnTo>
                    <a:pt x="248" y="2737"/>
                  </a:lnTo>
                  <a:lnTo>
                    <a:pt x="244" y="2739"/>
                  </a:lnTo>
                  <a:lnTo>
                    <a:pt x="6" y="2739"/>
                  </a:lnTo>
                  <a:lnTo>
                    <a:pt x="0" y="2737"/>
                  </a:lnTo>
                  <a:lnTo>
                    <a:pt x="0" y="2733"/>
                  </a:lnTo>
                  <a:lnTo>
                    <a:pt x="0" y="6"/>
                  </a:lnTo>
                  <a:close/>
                  <a:moveTo>
                    <a:pt x="12" y="2733"/>
                  </a:moveTo>
                  <a:lnTo>
                    <a:pt x="6" y="2727"/>
                  </a:lnTo>
                  <a:lnTo>
                    <a:pt x="244" y="2727"/>
                  </a:lnTo>
                  <a:lnTo>
                    <a:pt x="238" y="2733"/>
                  </a:lnTo>
                  <a:lnTo>
                    <a:pt x="238" y="6"/>
                  </a:lnTo>
                  <a:lnTo>
                    <a:pt x="244" y="12"/>
                  </a:lnTo>
                  <a:lnTo>
                    <a:pt x="6" y="12"/>
                  </a:lnTo>
                  <a:lnTo>
                    <a:pt x="12" y="6"/>
                  </a:lnTo>
                  <a:lnTo>
                    <a:pt x="12" y="2733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5" name="Freeform 24"/>
            <p:cNvSpPr>
              <a:spLocks noEditPoints="1"/>
            </p:cNvSpPr>
            <p:nvPr/>
          </p:nvSpPr>
          <p:spPr bwMode="auto">
            <a:xfrm>
              <a:off x="1446213" y="7886700"/>
              <a:ext cx="198438" cy="120650"/>
            </a:xfrm>
            <a:custGeom>
              <a:avLst/>
              <a:gdLst>
                <a:gd name="T0" fmla="*/ 0 w 250"/>
                <a:gd name="T1" fmla="*/ 6 h 154"/>
                <a:gd name="T2" fmla="*/ 0 w 250"/>
                <a:gd name="T3" fmla="*/ 0 h 154"/>
                <a:gd name="T4" fmla="*/ 6 w 250"/>
                <a:gd name="T5" fmla="*/ 0 h 154"/>
                <a:gd name="T6" fmla="*/ 244 w 250"/>
                <a:gd name="T7" fmla="*/ 0 h 154"/>
                <a:gd name="T8" fmla="*/ 248 w 250"/>
                <a:gd name="T9" fmla="*/ 0 h 154"/>
                <a:gd name="T10" fmla="*/ 250 w 250"/>
                <a:gd name="T11" fmla="*/ 6 h 154"/>
                <a:gd name="T12" fmla="*/ 250 w 250"/>
                <a:gd name="T13" fmla="*/ 148 h 154"/>
                <a:gd name="T14" fmla="*/ 248 w 250"/>
                <a:gd name="T15" fmla="*/ 152 h 154"/>
                <a:gd name="T16" fmla="*/ 244 w 250"/>
                <a:gd name="T17" fmla="*/ 154 h 154"/>
                <a:gd name="T18" fmla="*/ 6 w 250"/>
                <a:gd name="T19" fmla="*/ 154 h 154"/>
                <a:gd name="T20" fmla="*/ 0 w 250"/>
                <a:gd name="T21" fmla="*/ 152 h 154"/>
                <a:gd name="T22" fmla="*/ 0 w 250"/>
                <a:gd name="T23" fmla="*/ 148 h 154"/>
                <a:gd name="T24" fmla="*/ 0 w 250"/>
                <a:gd name="T25" fmla="*/ 6 h 154"/>
                <a:gd name="T26" fmla="*/ 12 w 250"/>
                <a:gd name="T27" fmla="*/ 148 h 154"/>
                <a:gd name="T28" fmla="*/ 6 w 250"/>
                <a:gd name="T29" fmla="*/ 142 h 154"/>
                <a:gd name="T30" fmla="*/ 244 w 250"/>
                <a:gd name="T31" fmla="*/ 142 h 154"/>
                <a:gd name="T32" fmla="*/ 238 w 250"/>
                <a:gd name="T33" fmla="*/ 148 h 154"/>
                <a:gd name="T34" fmla="*/ 238 w 250"/>
                <a:gd name="T35" fmla="*/ 6 h 154"/>
                <a:gd name="T36" fmla="*/ 244 w 250"/>
                <a:gd name="T37" fmla="*/ 12 h 154"/>
                <a:gd name="T38" fmla="*/ 6 w 250"/>
                <a:gd name="T39" fmla="*/ 12 h 154"/>
                <a:gd name="T40" fmla="*/ 12 w 250"/>
                <a:gd name="T41" fmla="*/ 6 h 154"/>
                <a:gd name="T42" fmla="*/ 12 w 250"/>
                <a:gd name="T43" fmla="*/ 148 h 15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50" h="154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244" y="0"/>
                  </a:lnTo>
                  <a:lnTo>
                    <a:pt x="248" y="0"/>
                  </a:lnTo>
                  <a:lnTo>
                    <a:pt x="250" y="6"/>
                  </a:lnTo>
                  <a:lnTo>
                    <a:pt x="250" y="148"/>
                  </a:lnTo>
                  <a:lnTo>
                    <a:pt x="248" y="152"/>
                  </a:lnTo>
                  <a:lnTo>
                    <a:pt x="244" y="154"/>
                  </a:lnTo>
                  <a:lnTo>
                    <a:pt x="6" y="154"/>
                  </a:lnTo>
                  <a:lnTo>
                    <a:pt x="0" y="152"/>
                  </a:lnTo>
                  <a:lnTo>
                    <a:pt x="0" y="148"/>
                  </a:lnTo>
                  <a:lnTo>
                    <a:pt x="0" y="6"/>
                  </a:lnTo>
                  <a:close/>
                  <a:moveTo>
                    <a:pt x="12" y="148"/>
                  </a:moveTo>
                  <a:lnTo>
                    <a:pt x="6" y="142"/>
                  </a:lnTo>
                  <a:lnTo>
                    <a:pt x="244" y="142"/>
                  </a:lnTo>
                  <a:lnTo>
                    <a:pt x="238" y="148"/>
                  </a:lnTo>
                  <a:lnTo>
                    <a:pt x="238" y="6"/>
                  </a:lnTo>
                  <a:lnTo>
                    <a:pt x="244" y="12"/>
                  </a:lnTo>
                  <a:lnTo>
                    <a:pt x="6" y="12"/>
                  </a:lnTo>
                  <a:lnTo>
                    <a:pt x="12" y="6"/>
                  </a:lnTo>
                  <a:lnTo>
                    <a:pt x="12" y="148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7" name="Freeform 25"/>
            <p:cNvSpPr>
              <a:spLocks noEditPoints="1"/>
            </p:cNvSpPr>
            <p:nvPr/>
          </p:nvSpPr>
          <p:spPr bwMode="auto">
            <a:xfrm>
              <a:off x="1919288" y="7904163"/>
              <a:ext cx="196850" cy="103188"/>
            </a:xfrm>
            <a:custGeom>
              <a:avLst/>
              <a:gdLst>
                <a:gd name="T0" fmla="*/ 0 w 250"/>
                <a:gd name="T1" fmla="*/ 6 h 131"/>
                <a:gd name="T2" fmla="*/ 0 w 250"/>
                <a:gd name="T3" fmla="*/ 0 h 131"/>
                <a:gd name="T4" fmla="*/ 6 w 250"/>
                <a:gd name="T5" fmla="*/ 0 h 131"/>
                <a:gd name="T6" fmla="*/ 244 w 250"/>
                <a:gd name="T7" fmla="*/ 0 h 131"/>
                <a:gd name="T8" fmla="*/ 248 w 250"/>
                <a:gd name="T9" fmla="*/ 0 h 131"/>
                <a:gd name="T10" fmla="*/ 250 w 250"/>
                <a:gd name="T11" fmla="*/ 6 h 131"/>
                <a:gd name="T12" fmla="*/ 250 w 250"/>
                <a:gd name="T13" fmla="*/ 125 h 131"/>
                <a:gd name="T14" fmla="*/ 248 w 250"/>
                <a:gd name="T15" fmla="*/ 129 h 131"/>
                <a:gd name="T16" fmla="*/ 244 w 250"/>
                <a:gd name="T17" fmla="*/ 131 h 131"/>
                <a:gd name="T18" fmla="*/ 6 w 250"/>
                <a:gd name="T19" fmla="*/ 131 h 131"/>
                <a:gd name="T20" fmla="*/ 0 w 250"/>
                <a:gd name="T21" fmla="*/ 129 h 131"/>
                <a:gd name="T22" fmla="*/ 0 w 250"/>
                <a:gd name="T23" fmla="*/ 125 h 131"/>
                <a:gd name="T24" fmla="*/ 0 w 250"/>
                <a:gd name="T25" fmla="*/ 6 h 131"/>
                <a:gd name="T26" fmla="*/ 12 w 250"/>
                <a:gd name="T27" fmla="*/ 125 h 131"/>
                <a:gd name="T28" fmla="*/ 6 w 250"/>
                <a:gd name="T29" fmla="*/ 119 h 131"/>
                <a:gd name="T30" fmla="*/ 244 w 250"/>
                <a:gd name="T31" fmla="*/ 119 h 131"/>
                <a:gd name="T32" fmla="*/ 238 w 250"/>
                <a:gd name="T33" fmla="*/ 125 h 131"/>
                <a:gd name="T34" fmla="*/ 238 w 250"/>
                <a:gd name="T35" fmla="*/ 6 h 131"/>
                <a:gd name="T36" fmla="*/ 244 w 250"/>
                <a:gd name="T37" fmla="*/ 12 h 131"/>
                <a:gd name="T38" fmla="*/ 6 w 250"/>
                <a:gd name="T39" fmla="*/ 12 h 131"/>
                <a:gd name="T40" fmla="*/ 12 w 250"/>
                <a:gd name="T41" fmla="*/ 6 h 131"/>
                <a:gd name="T42" fmla="*/ 12 w 250"/>
                <a:gd name="T43" fmla="*/ 125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250" h="131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244" y="0"/>
                  </a:lnTo>
                  <a:lnTo>
                    <a:pt x="248" y="0"/>
                  </a:lnTo>
                  <a:lnTo>
                    <a:pt x="250" y="6"/>
                  </a:lnTo>
                  <a:lnTo>
                    <a:pt x="250" y="125"/>
                  </a:lnTo>
                  <a:lnTo>
                    <a:pt x="248" y="129"/>
                  </a:lnTo>
                  <a:lnTo>
                    <a:pt x="244" y="131"/>
                  </a:lnTo>
                  <a:lnTo>
                    <a:pt x="6" y="131"/>
                  </a:lnTo>
                  <a:lnTo>
                    <a:pt x="0" y="129"/>
                  </a:lnTo>
                  <a:lnTo>
                    <a:pt x="0" y="125"/>
                  </a:lnTo>
                  <a:lnTo>
                    <a:pt x="0" y="6"/>
                  </a:lnTo>
                  <a:close/>
                  <a:moveTo>
                    <a:pt x="12" y="125"/>
                  </a:moveTo>
                  <a:lnTo>
                    <a:pt x="6" y="119"/>
                  </a:lnTo>
                  <a:lnTo>
                    <a:pt x="244" y="119"/>
                  </a:lnTo>
                  <a:lnTo>
                    <a:pt x="238" y="125"/>
                  </a:lnTo>
                  <a:lnTo>
                    <a:pt x="238" y="6"/>
                  </a:lnTo>
                  <a:lnTo>
                    <a:pt x="244" y="12"/>
                  </a:lnTo>
                  <a:lnTo>
                    <a:pt x="6" y="12"/>
                  </a:lnTo>
                  <a:lnTo>
                    <a:pt x="12" y="6"/>
                  </a:lnTo>
                  <a:lnTo>
                    <a:pt x="12" y="125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028" name="Rectangle 26"/>
            <p:cNvSpPr>
              <a:spLocks noChangeArrowheads="1"/>
            </p:cNvSpPr>
            <p:nvPr/>
          </p:nvSpPr>
          <p:spPr bwMode="auto">
            <a:xfrm>
              <a:off x="831850" y="5599113"/>
              <a:ext cx="9525" cy="2405063"/>
            </a:xfrm>
            <a:prstGeom prst="rect">
              <a:avLst/>
            </a:prstGeom>
            <a:solidFill>
              <a:srgbClr val="868686"/>
            </a:solidFill>
            <a:ln w="1588">
              <a:solidFill>
                <a:srgbClr val="868686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036" name="グループ化 1035"/>
          <p:cNvGrpSpPr/>
          <p:nvPr/>
        </p:nvGrpSpPr>
        <p:grpSpPr>
          <a:xfrm>
            <a:off x="1154234" y="1762901"/>
            <a:ext cx="128240" cy="1948953"/>
            <a:chOff x="590550" y="5513388"/>
            <a:chExt cx="128240" cy="1948953"/>
          </a:xfrm>
        </p:grpSpPr>
        <p:sp>
          <p:nvSpPr>
            <p:cNvPr id="1030" name="Rectangle 28"/>
            <p:cNvSpPr>
              <a:spLocks noChangeArrowheads="1"/>
            </p:cNvSpPr>
            <p:nvPr/>
          </p:nvSpPr>
          <p:spPr bwMode="auto">
            <a:xfrm>
              <a:off x="654050" y="7308453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1" name="Rectangle 29"/>
            <p:cNvSpPr>
              <a:spLocks noChangeArrowheads="1"/>
            </p:cNvSpPr>
            <p:nvPr/>
          </p:nvSpPr>
          <p:spPr bwMode="auto">
            <a:xfrm>
              <a:off x="654050" y="6859686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2" name="Rectangle 30"/>
            <p:cNvSpPr>
              <a:spLocks noChangeArrowheads="1"/>
            </p:cNvSpPr>
            <p:nvPr/>
          </p:nvSpPr>
          <p:spPr bwMode="auto">
            <a:xfrm>
              <a:off x="590550" y="6410920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3" name="Rectangle 31"/>
            <p:cNvSpPr>
              <a:spLocks noChangeArrowheads="1"/>
            </p:cNvSpPr>
            <p:nvPr/>
          </p:nvSpPr>
          <p:spPr bwMode="auto">
            <a:xfrm>
              <a:off x="590550" y="5962154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4" name="Rectangle 32"/>
            <p:cNvSpPr>
              <a:spLocks noChangeArrowheads="1"/>
            </p:cNvSpPr>
            <p:nvPr/>
          </p:nvSpPr>
          <p:spPr bwMode="auto">
            <a:xfrm>
              <a:off x="590550" y="5513388"/>
              <a:ext cx="1282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2" name="グループ化 101"/>
          <p:cNvGrpSpPr/>
          <p:nvPr/>
        </p:nvGrpSpPr>
        <p:grpSpPr>
          <a:xfrm>
            <a:off x="1436526" y="3635109"/>
            <a:ext cx="878189" cy="153888"/>
            <a:chOff x="1339873" y="2793521"/>
            <a:chExt cx="878189" cy="153888"/>
          </a:xfrm>
        </p:grpSpPr>
        <p:sp>
          <p:nvSpPr>
            <p:cNvPr id="103" name="Rectangle 21"/>
            <p:cNvSpPr>
              <a:spLocks noChangeArrowheads="1"/>
            </p:cNvSpPr>
            <p:nvPr/>
          </p:nvSpPr>
          <p:spPr bwMode="auto">
            <a:xfrm>
              <a:off x="1339873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" name="Rectangle 22"/>
            <p:cNvSpPr>
              <a:spLocks noChangeArrowheads="1"/>
            </p:cNvSpPr>
            <p:nvPr/>
          </p:nvSpPr>
          <p:spPr bwMode="auto">
            <a:xfrm>
              <a:off x="170092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Rectangle 23"/>
            <p:cNvSpPr>
              <a:spLocks noChangeArrowheads="1"/>
            </p:cNvSpPr>
            <p:nvPr/>
          </p:nvSpPr>
          <p:spPr bwMode="auto">
            <a:xfrm>
              <a:off x="206096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055" name="グループ化 1054"/>
          <p:cNvGrpSpPr/>
          <p:nvPr/>
        </p:nvGrpSpPr>
        <p:grpSpPr>
          <a:xfrm>
            <a:off x="2780928" y="1751026"/>
            <a:ext cx="1424822" cy="1911501"/>
            <a:chOff x="2852403" y="6474891"/>
            <a:chExt cx="1424822" cy="1911501"/>
          </a:xfrm>
        </p:grpSpPr>
        <p:grpSp>
          <p:nvGrpSpPr>
            <p:cNvPr id="1054" name="グループ化 1053"/>
            <p:cNvGrpSpPr/>
            <p:nvPr/>
          </p:nvGrpSpPr>
          <p:grpSpPr>
            <a:xfrm>
              <a:off x="3197225" y="6529388"/>
              <a:ext cx="1080000" cy="1800000"/>
              <a:chOff x="3197225" y="6529388"/>
              <a:chExt cx="1193800" cy="1860550"/>
            </a:xfrm>
          </p:grpSpPr>
          <p:sp>
            <p:nvSpPr>
              <p:cNvPr id="1039" name="Freeform 37"/>
              <p:cNvSpPr>
                <a:spLocks noEditPoints="1"/>
              </p:cNvSpPr>
              <p:nvPr/>
            </p:nvSpPr>
            <p:spPr bwMode="auto">
              <a:xfrm>
                <a:off x="3197225" y="6529388"/>
                <a:ext cx="1193800" cy="1860550"/>
              </a:xfrm>
              <a:custGeom>
                <a:avLst/>
                <a:gdLst>
                  <a:gd name="T0" fmla="*/ 0 w 1503"/>
                  <a:gd name="T1" fmla="*/ 6 h 2342"/>
                  <a:gd name="T2" fmla="*/ 0 w 1503"/>
                  <a:gd name="T3" fmla="*/ 0 h 2342"/>
                  <a:gd name="T4" fmla="*/ 6 w 1503"/>
                  <a:gd name="T5" fmla="*/ 0 h 2342"/>
                  <a:gd name="T6" fmla="*/ 1497 w 1503"/>
                  <a:gd name="T7" fmla="*/ 0 h 2342"/>
                  <a:gd name="T8" fmla="*/ 1501 w 1503"/>
                  <a:gd name="T9" fmla="*/ 0 h 2342"/>
                  <a:gd name="T10" fmla="*/ 1503 w 1503"/>
                  <a:gd name="T11" fmla="*/ 6 h 2342"/>
                  <a:gd name="T12" fmla="*/ 1503 w 1503"/>
                  <a:gd name="T13" fmla="*/ 2336 h 2342"/>
                  <a:gd name="T14" fmla="*/ 1501 w 1503"/>
                  <a:gd name="T15" fmla="*/ 2340 h 2342"/>
                  <a:gd name="T16" fmla="*/ 1497 w 1503"/>
                  <a:gd name="T17" fmla="*/ 2342 h 2342"/>
                  <a:gd name="T18" fmla="*/ 6 w 1503"/>
                  <a:gd name="T19" fmla="*/ 2342 h 2342"/>
                  <a:gd name="T20" fmla="*/ 0 w 1503"/>
                  <a:gd name="T21" fmla="*/ 2340 h 2342"/>
                  <a:gd name="T22" fmla="*/ 0 w 1503"/>
                  <a:gd name="T23" fmla="*/ 2336 h 2342"/>
                  <a:gd name="T24" fmla="*/ 0 w 1503"/>
                  <a:gd name="T25" fmla="*/ 6 h 2342"/>
                  <a:gd name="T26" fmla="*/ 12 w 1503"/>
                  <a:gd name="T27" fmla="*/ 2336 h 2342"/>
                  <a:gd name="T28" fmla="*/ 6 w 1503"/>
                  <a:gd name="T29" fmla="*/ 2331 h 2342"/>
                  <a:gd name="T30" fmla="*/ 1497 w 1503"/>
                  <a:gd name="T31" fmla="*/ 2331 h 2342"/>
                  <a:gd name="T32" fmla="*/ 1492 w 1503"/>
                  <a:gd name="T33" fmla="*/ 2336 h 2342"/>
                  <a:gd name="T34" fmla="*/ 1492 w 1503"/>
                  <a:gd name="T35" fmla="*/ 6 h 2342"/>
                  <a:gd name="T36" fmla="*/ 1497 w 1503"/>
                  <a:gd name="T37" fmla="*/ 11 h 2342"/>
                  <a:gd name="T38" fmla="*/ 6 w 1503"/>
                  <a:gd name="T39" fmla="*/ 11 h 2342"/>
                  <a:gd name="T40" fmla="*/ 12 w 1503"/>
                  <a:gd name="T41" fmla="*/ 6 h 2342"/>
                  <a:gd name="T42" fmla="*/ 12 w 1503"/>
                  <a:gd name="T43" fmla="*/ 2336 h 23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1503" h="2342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  <a:lnTo>
                      <a:pt x="1497" y="0"/>
                    </a:lnTo>
                    <a:lnTo>
                      <a:pt x="1501" y="0"/>
                    </a:lnTo>
                    <a:lnTo>
                      <a:pt x="1503" y="6"/>
                    </a:lnTo>
                    <a:lnTo>
                      <a:pt x="1503" y="2336"/>
                    </a:lnTo>
                    <a:lnTo>
                      <a:pt x="1501" y="2340"/>
                    </a:lnTo>
                    <a:lnTo>
                      <a:pt x="1497" y="2342"/>
                    </a:lnTo>
                    <a:lnTo>
                      <a:pt x="6" y="2342"/>
                    </a:lnTo>
                    <a:lnTo>
                      <a:pt x="0" y="2340"/>
                    </a:lnTo>
                    <a:lnTo>
                      <a:pt x="0" y="2336"/>
                    </a:lnTo>
                    <a:lnTo>
                      <a:pt x="0" y="6"/>
                    </a:lnTo>
                    <a:close/>
                    <a:moveTo>
                      <a:pt x="12" y="2336"/>
                    </a:moveTo>
                    <a:lnTo>
                      <a:pt x="6" y="2331"/>
                    </a:lnTo>
                    <a:lnTo>
                      <a:pt x="1497" y="2331"/>
                    </a:lnTo>
                    <a:lnTo>
                      <a:pt x="1492" y="2336"/>
                    </a:lnTo>
                    <a:lnTo>
                      <a:pt x="1492" y="6"/>
                    </a:lnTo>
                    <a:lnTo>
                      <a:pt x="1497" y="11"/>
                    </a:lnTo>
                    <a:lnTo>
                      <a:pt x="6" y="11"/>
                    </a:lnTo>
                    <a:lnTo>
                      <a:pt x="12" y="6"/>
                    </a:lnTo>
                    <a:lnTo>
                      <a:pt x="12" y="2336"/>
                    </a:lnTo>
                    <a:close/>
                  </a:path>
                </a:pathLst>
              </a:cu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0" name="Freeform 38"/>
              <p:cNvSpPr>
                <a:spLocks noEditPoints="1"/>
              </p:cNvSpPr>
              <p:nvPr/>
            </p:nvSpPr>
            <p:spPr bwMode="auto">
              <a:xfrm>
                <a:off x="3316288" y="6734175"/>
                <a:ext cx="166687" cy="1655762"/>
              </a:xfrm>
              <a:custGeom>
                <a:avLst/>
                <a:gdLst>
                  <a:gd name="T0" fmla="*/ 0 w 211"/>
                  <a:gd name="T1" fmla="*/ 6 h 2085"/>
                  <a:gd name="T2" fmla="*/ 0 w 211"/>
                  <a:gd name="T3" fmla="*/ 0 h 2085"/>
                  <a:gd name="T4" fmla="*/ 6 w 211"/>
                  <a:gd name="T5" fmla="*/ 0 h 2085"/>
                  <a:gd name="T6" fmla="*/ 205 w 211"/>
                  <a:gd name="T7" fmla="*/ 0 h 2085"/>
                  <a:gd name="T8" fmla="*/ 209 w 211"/>
                  <a:gd name="T9" fmla="*/ 0 h 2085"/>
                  <a:gd name="T10" fmla="*/ 211 w 211"/>
                  <a:gd name="T11" fmla="*/ 6 h 2085"/>
                  <a:gd name="T12" fmla="*/ 211 w 211"/>
                  <a:gd name="T13" fmla="*/ 2079 h 2085"/>
                  <a:gd name="T14" fmla="*/ 209 w 211"/>
                  <a:gd name="T15" fmla="*/ 2083 h 2085"/>
                  <a:gd name="T16" fmla="*/ 205 w 211"/>
                  <a:gd name="T17" fmla="*/ 2085 h 2085"/>
                  <a:gd name="T18" fmla="*/ 6 w 211"/>
                  <a:gd name="T19" fmla="*/ 2085 h 2085"/>
                  <a:gd name="T20" fmla="*/ 0 w 211"/>
                  <a:gd name="T21" fmla="*/ 2083 h 2085"/>
                  <a:gd name="T22" fmla="*/ 0 w 211"/>
                  <a:gd name="T23" fmla="*/ 2079 h 2085"/>
                  <a:gd name="T24" fmla="*/ 0 w 211"/>
                  <a:gd name="T25" fmla="*/ 6 h 2085"/>
                  <a:gd name="T26" fmla="*/ 11 w 211"/>
                  <a:gd name="T27" fmla="*/ 2079 h 2085"/>
                  <a:gd name="T28" fmla="*/ 6 w 211"/>
                  <a:gd name="T29" fmla="*/ 2074 h 2085"/>
                  <a:gd name="T30" fmla="*/ 205 w 211"/>
                  <a:gd name="T31" fmla="*/ 2074 h 2085"/>
                  <a:gd name="T32" fmla="*/ 199 w 211"/>
                  <a:gd name="T33" fmla="*/ 2079 h 2085"/>
                  <a:gd name="T34" fmla="*/ 199 w 211"/>
                  <a:gd name="T35" fmla="*/ 6 h 2085"/>
                  <a:gd name="T36" fmla="*/ 205 w 211"/>
                  <a:gd name="T37" fmla="*/ 12 h 2085"/>
                  <a:gd name="T38" fmla="*/ 6 w 211"/>
                  <a:gd name="T39" fmla="*/ 12 h 2085"/>
                  <a:gd name="T40" fmla="*/ 11 w 211"/>
                  <a:gd name="T41" fmla="*/ 6 h 2085"/>
                  <a:gd name="T42" fmla="*/ 11 w 211"/>
                  <a:gd name="T43" fmla="*/ 2079 h 208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211" h="2085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  <a:lnTo>
                      <a:pt x="205" y="0"/>
                    </a:lnTo>
                    <a:lnTo>
                      <a:pt x="209" y="0"/>
                    </a:lnTo>
                    <a:lnTo>
                      <a:pt x="211" y="6"/>
                    </a:lnTo>
                    <a:lnTo>
                      <a:pt x="211" y="2079"/>
                    </a:lnTo>
                    <a:lnTo>
                      <a:pt x="209" y="2083"/>
                    </a:lnTo>
                    <a:lnTo>
                      <a:pt x="205" y="2085"/>
                    </a:lnTo>
                    <a:lnTo>
                      <a:pt x="6" y="2085"/>
                    </a:lnTo>
                    <a:lnTo>
                      <a:pt x="0" y="2083"/>
                    </a:lnTo>
                    <a:lnTo>
                      <a:pt x="0" y="2079"/>
                    </a:lnTo>
                    <a:lnTo>
                      <a:pt x="0" y="6"/>
                    </a:lnTo>
                    <a:close/>
                    <a:moveTo>
                      <a:pt x="11" y="2079"/>
                    </a:moveTo>
                    <a:lnTo>
                      <a:pt x="6" y="2074"/>
                    </a:lnTo>
                    <a:lnTo>
                      <a:pt x="205" y="2074"/>
                    </a:lnTo>
                    <a:lnTo>
                      <a:pt x="199" y="2079"/>
                    </a:lnTo>
                    <a:lnTo>
                      <a:pt x="199" y="6"/>
                    </a:lnTo>
                    <a:lnTo>
                      <a:pt x="205" y="12"/>
                    </a:lnTo>
                    <a:lnTo>
                      <a:pt x="6" y="12"/>
                    </a:lnTo>
                    <a:lnTo>
                      <a:pt x="11" y="6"/>
                    </a:lnTo>
                    <a:lnTo>
                      <a:pt x="11" y="2079"/>
                    </a:lnTo>
                    <a:close/>
                  </a:path>
                </a:pathLst>
              </a:cu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1" name="Freeform 39"/>
              <p:cNvSpPr>
                <a:spLocks noEditPoints="1"/>
              </p:cNvSpPr>
              <p:nvPr/>
            </p:nvSpPr>
            <p:spPr bwMode="auto">
              <a:xfrm>
                <a:off x="3709988" y="8242300"/>
                <a:ext cx="168275" cy="147637"/>
              </a:xfrm>
              <a:custGeom>
                <a:avLst/>
                <a:gdLst>
                  <a:gd name="T0" fmla="*/ 0 w 211"/>
                  <a:gd name="T1" fmla="*/ 6 h 184"/>
                  <a:gd name="T2" fmla="*/ 0 w 211"/>
                  <a:gd name="T3" fmla="*/ 0 h 184"/>
                  <a:gd name="T4" fmla="*/ 6 w 211"/>
                  <a:gd name="T5" fmla="*/ 0 h 184"/>
                  <a:gd name="T6" fmla="*/ 205 w 211"/>
                  <a:gd name="T7" fmla="*/ 0 h 184"/>
                  <a:gd name="T8" fmla="*/ 209 w 211"/>
                  <a:gd name="T9" fmla="*/ 0 h 184"/>
                  <a:gd name="T10" fmla="*/ 211 w 211"/>
                  <a:gd name="T11" fmla="*/ 6 h 184"/>
                  <a:gd name="T12" fmla="*/ 211 w 211"/>
                  <a:gd name="T13" fmla="*/ 178 h 184"/>
                  <a:gd name="T14" fmla="*/ 209 w 211"/>
                  <a:gd name="T15" fmla="*/ 182 h 184"/>
                  <a:gd name="T16" fmla="*/ 205 w 211"/>
                  <a:gd name="T17" fmla="*/ 184 h 184"/>
                  <a:gd name="T18" fmla="*/ 6 w 211"/>
                  <a:gd name="T19" fmla="*/ 184 h 184"/>
                  <a:gd name="T20" fmla="*/ 0 w 211"/>
                  <a:gd name="T21" fmla="*/ 182 h 184"/>
                  <a:gd name="T22" fmla="*/ 0 w 211"/>
                  <a:gd name="T23" fmla="*/ 178 h 184"/>
                  <a:gd name="T24" fmla="*/ 0 w 211"/>
                  <a:gd name="T25" fmla="*/ 6 h 184"/>
                  <a:gd name="T26" fmla="*/ 11 w 211"/>
                  <a:gd name="T27" fmla="*/ 178 h 184"/>
                  <a:gd name="T28" fmla="*/ 6 w 211"/>
                  <a:gd name="T29" fmla="*/ 173 h 184"/>
                  <a:gd name="T30" fmla="*/ 205 w 211"/>
                  <a:gd name="T31" fmla="*/ 173 h 184"/>
                  <a:gd name="T32" fmla="*/ 200 w 211"/>
                  <a:gd name="T33" fmla="*/ 178 h 184"/>
                  <a:gd name="T34" fmla="*/ 200 w 211"/>
                  <a:gd name="T35" fmla="*/ 6 h 184"/>
                  <a:gd name="T36" fmla="*/ 205 w 211"/>
                  <a:gd name="T37" fmla="*/ 11 h 184"/>
                  <a:gd name="T38" fmla="*/ 6 w 211"/>
                  <a:gd name="T39" fmla="*/ 11 h 184"/>
                  <a:gd name="T40" fmla="*/ 11 w 211"/>
                  <a:gd name="T41" fmla="*/ 6 h 184"/>
                  <a:gd name="T42" fmla="*/ 11 w 211"/>
                  <a:gd name="T43" fmla="*/ 178 h 18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211" h="184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  <a:lnTo>
                      <a:pt x="205" y="0"/>
                    </a:lnTo>
                    <a:lnTo>
                      <a:pt x="209" y="0"/>
                    </a:lnTo>
                    <a:lnTo>
                      <a:pt x="211" y="6"/>
                    </a:lnTo>
                    <a:lnTo>
                      <a:pt x="211" y="178"/>
                    </a:lnTo>
                    <a:lnTo>
                      <a:pt x="209" y="182"/>
                    </a:lnTo>
                    <a:lnTo>
                      <a:pt x="205" y="184"/>
                    </a:lnTo>
                    <a:lnTo>
                      <a:pt x="6" y="184"/>
                    </a:lnTo>
                    <a:lnTo>
                      <a:pt x="0" y="182"/>
                    </a:lnTo>
                    <a:lnTo>
                      <a:pt x="0" y="178"/>
                    </a:lnTo>
                    <a:lnTo>
                      <a:pt x="0" y="6"/>
                    </a:lnTo>
                    <a:close/>
                    <a:moveTo>
                      <a:pt x="11" y="178"/>
                    </a:moveTo>
                    <a:lnTo>
                      <a:pt x="6" y="173"/>
                    </a:lnTo>
                    <a:lnTo>
                      <a:pt x="205" y="173"/>
                    </a:lnTo>
                    <a:lnTo>
                      <a:pt x="200" y="178"/>
                    </a:lnTo>
                    <a:lnTo>
                      <a:pt x="200" y="6"/>
                    </a:lnTo>
                    <a:lnTo>
                      <a:pt x="205" y="11"/>
                    </a:lnTo>
                    <a:lnTo>
                      <a:pt x="6" y="11"/>
                    </a:lnTo>
                    <a:lnTo>
                      <a:pt x="11" y="6"/>
                    </a:lnTo>
                    <a:lnTo>
                      <a:pt x="11" y="178"/>
                    </a:lnTo>
                    <a:close/>
                  </a:path>
                </a:pathLst>
              </a:cu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3" name="Freeform 40"/>
              <p:cNvSpPr>
                <a:spLocks noEditPoints="1"/>
              </p:cNvSpPr>
              <p:nvPr/>
            </p:nvSpPr>
            <p:spPr bwMode="auto">
              <a:xfrm>
                <a:off x="4105275" y="8272463"/>
                <a:ext cx="166687" cy="117475"/>
              </a:xfrm>
              <a:custGeom>
                <a:avLst/>
                <a:gdLst>
                  <a:gd name="T0" fmla="*/ 0 w 209"/>
                  <a:gd name="T1" fmla="*/ 6 h 148"/>
                  <a:gd name="T2" fmla="*/ 0 w 209"/>
                  <a:gd name="T3" fmla="*/ 0 h 148"/>
                  <a:gd name="T4" fmla="*/ 6 w 209"/>
                  <a:gd name="T5" fmla="*/ 0 h 148"/>
                  <a:gd name="T6" fmla="*/ 204 w 209"/>
                  <a:gd name="T7" fmla="*/ 0 h 148"/>
                  <a:gd name="T8" fmla="*/ 207 w 209"/>
                  <a:gd name="T9" fmla="*/ 0 h 148"/>
                  <a:gd name="T10" fmla="*/ 209 w 209"/>
                  <a:gd name="T11" fmla="*/ 6 h 148"/>
                  <a:gd name="T12" fmla="*/ 209 w 209"/>
                  <a:gd name="T13" fmla="*/ 142 h 148"/>
                  <a:gd name="T14" fmla="*/ 207 w 209"/>
                  <a:gd name="T15" fmla="*/ 146 h 148"/>
                  <a:gd name="T16" fmla="*/ 204 w 209"/>
                  <a:gd name="T17" fmla="*/ 148 h 148"/>
                  <a:gd name="T18" fmla="*/ 6 w 209"/>
                  <a:gd name="T19" fmla="*/ 148 h 148"/>
                  <a:gd name="T20" fmla="*/ 0 w 209"/>
                  <a:gd name="T21" fmla="*/ 146 h 148"/>
                  <a:gd name="T22" fmla="*/ 0 w 209"/>
                  <a:gd name="T23" fmla="*/ 142 h 148"/>
                  <a:gd name="T24" fmla="*/ 0 w 209"/>
                  <a:gd name="T25" fmla="*/ 6 h 148"/>
                  <a:gd name="T26" fmla="*/ 12 w 209"/>
                  <a:gd name="T27" fmla="*/ 142 h 148"/>
                  <a:gd name="T28" fmla="*/ 6 w 209"/>
                  <a:gd name="T29" fmla="*/ 137 h 148"/>
                  <a:gd name="T30" fmla="*/ 204 w 209"/>
                  <a:gd name="T31" fmla="*/ 137 h 148"/>
                  <a:gd name="T32" fmla="*/ 198 w 209"/>
                  <a:gd name="T33" fmla="*/ 142 h 148"/>
                  <a:gd name="T34" fmla="*/ 198 w 209"/>
                  <a:gd name="T35" fmla="*/ 6 h 148"/>
                  <a:gd name="T36" fmla="*/ 204 w 209"/>
                  <a:gd name="T37" fmla="*/ 12 h 148"/>
                  <a:gd name="T38" fmla="*/ 6 w 209"/>
                  <a:gd name="T39" fmla="*/ 12 h 148"/>
                  <a:gd name="T40" fmla="*/ 12 w 209"/>
                  <a:gd name="T41" fmla="*/ 6 h 148"/>
                  <a:gd name="T42" fmla="*/ 12 w 209"/>
                  <a:gd name="T43" fmla="*/ 142 h 1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209" h="148">
                    <a:moveTo>
                      <a:pt x="0" y="6"/>
                    </a:moveTo>
                    <a:lnTo>
                      <a:pt x="0" y="0"/>
                    </a:lnTo>
                    <a:lnTo>
                      <a:pt x="6" y="0"/>
                    </a:lnTo>
                    <a:lnTo>
                      <a:pt x="204" y="0"/>
                    </a:lnTo>
                    <a:lnTo>
                      <a:pt x="207" y="0"/>
                    </a:lnTo>
                    <a:lnTo>
                      <a:pt x="209" y="6"/>
                    </a:lnTo>
                    <a:lnTo>
                      <a:pt x="209" y="142"/>
                    </a:lnTo>
                    <a:lnTo>
                      <a:pt x="207" y="146"/>
                    </a:lnTo>
                    <a:lnTo>
                      <a:pt x="204" y="148"/>
                    </a:lnTo>
                    <a:lnTo>
                      <a:pt x="6" y="148"/>
                    </a:lnTo>
                    <a:lnTo>
                      <a:pt x="0" y="146"/>
                    </a:lnTo>
                    <a:lnTo>
                      <a:pt x="0" y="142"/>
                    </a:lnTo>
                    <a:lnTo>
                      <a:pt x="0" y="6"/>
                    </a:lnTo>
                    <a:close/>
                    <a:moveTo>
                      <a:pt x="12" y="142"/>
                    </a:moveTo>
                    <a:lnTo>
                      <a:pt x="6" y="137"/>
                    </a:lnTo>
                    <a:lnTo>
                      <a:pt x="204" y="137"/>
                    </a:lnTo>
                    <a:lnTo>
                      <a:pt x="198" y="142"/>
                    </a:lnTo>
                    <a:lnTo>
                      <a:pt x="198" y="6"/>
                    </a:lnTo>
                    <a:lnTo>
                      <a:pt x="204" y="12"/>
                    </a:lnTo>
                    <a:lnTo>
                      <a:pt x="6" y="12"/>
                    </a:lnTo>
                    <a:lnTo>
                      <a:pt x="12" y="6"/>
                    </a:lnTo>
                    <a:lnTo>
                      <a:pt x="12" y="142"/>
                    </a:lnTo>
                    <a:close/>
                  </a:path>
                </a:pathLst>
              </a:custGeom>
              <a:solidFill>
                <a:srgbClr val="000000"/>
              </a:solidFill>
              <a:ln w="1588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1044" name="Rectangle 41"/>
              <p:cNvSpPr>
                <a:spLocks noChangeArrowheads="1"/>
              </p:cNvSpPr>
              <p:nvPr/>
            </p:nvSpPr>
            <p:spPr bwMode="auto">
              <a:xfrm>
                <a:off x="3197225" y="6534150"/>
                <a:ext cx="9525" cy="1851025"/>
              </a:xfrm>
              <a:prstGeom prst="rect">
                <a:avLst/>
              </a:prstGeom>
              <a:solidFill>
                <a:srgbClr val="868686"/>
              </a:solidFill>
              <a:ln w="1588">
                <a:solidFill>
                  <a:srgbClr val="868686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  <p:sp>
          <p:nvSpPr>
            <p:cNvPr id="1046" name="Rectangle 43"/>
            <p:cNvSpPr>
              <a:spLocks noChangeArrowheads="1"/>
            </p:cNvSpPr>
            <p:nvPr/>
          </p:nvSpPr>
          <p:spPr bwMode="auto">
            <a:xfrm>
              <a:off x="3044763" y="8232504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7" name="Rectangle 44"/>
            <p:cNvSpPr>
              <a:spLocks noChangeArrowheads="1"/>
            </p:cNvSpPr>
            <p:nvPr/>
          </p:nvSpPr>
          <p:spPr bwMode="auto">
            <a:xfrm>
              <a:off x="2916523" y="7981419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8" name="Rectangle 45"/>
            <p:cNvSpPr>
              <a:spLocks noChangeArrowheads="1"/>
            </p:cNvSpPr>
            <p:nvPr/>
          </p:nvSpPr>
          <p:spPr bwMode="auto">
            <a:xfrm>
              <a:off x="2916523" y="7730331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49" name="Rectangle 46"/>
            <p:cNvSpPr>
              <a:spLocks noChangeArrowheads="1"/>
            </p:cNvSpPr>
            <p:nvPr/>
          </p:nvSpPr>
          <p:spPr bwMode="auto">
            <a:xfrm>
              <a:off x="2916523" y="7479243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0" name="Rectangle 47"/>
            <p:cNvSpPr>
              <a:spLocks noChangeArrowheads="1"/>
            </p:cNvSpPr>
            <p:nvPr/>
          </p:nvSpPr>
          <p:spPr bwMode="auto">
            <a:xfrm>
              <a:off x="2916523" y="7228155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1" name="Rectangle 48"/>
            <p:cNvSpPr>
              <a:spLocks noChangeArrowheads="1"/>
            </p:cNvSpPr>
            <p:nvPr/>
          </p:nvSpPr>
          <p:spPr bwMode="auto">
            <a:xfrm>
              <a:off x="2852403" y="6977067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2" name="Rectangle 49"/>
            <p:cNvSpPr>
              <a:spLocks noChangeArrowheads="1"/>
            </p:cNvSpPr>
            <p:nvPr/>
          </p:nvSpPr>
          <p:spPr bwMode="auto">
            <a:xfrm>
              <a:off x="2852403" y="6725979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3" name="Rectangle 50"/>
            <p:cNvSpPr>
              <a:spLocks noChangeArrowheads="1"/>
            </p:cNvSpPr>
            <p:nvPr/>
          </p:nvSpPr>
          <p:spPr bwMode="auto">
            <a:xfrm>
              <a:off x="2852403" y="6474891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5" name="グループ化 124"/>
          <p:cNvGrpSpPr/>
          <p:nvPr/>
        </p:nvGrpSpPr>
        <p:grpSpPr>
          <a:xfrm>
            <a:off x="3224851" y="3635867"/>
            <a:ext cx="878189" cy="153888"/>
            <a:chOff x="1339873" y="2793521"/>
            <a:chExt cx="878189" cy="153888"/>
          </a:xfrm>
        </p:grpSpPr>
        <p:sp>
          <p:nvSpPr>
            <p:cNvPr id="126" name="Rectangle 21"/>
            <p:cNvSpPr>
              <a:spLocks noChangeArrowheads="1"/>
            </p:cNvSpPr>
            <p:nvPr/>
          </p:nvSpPr>
          <p:spPr bwMode="auto">
            <a:xfrm>
              <a:off x="1339873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7" name="Rectangle 22"/>
            <p:cNvSpPr>
              <a:spLocks noChangeArrowheads="1"/>
            </p:cNvSpPr>
            <p:nvPr/>
          </p:nvSpPr>
          <p:spPr bwMode="auto">
            <a:xfrm>
              <a:off x="170092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8" name="Rectangle 23"/>
            <p:cNvSpPr>
              <a:spLocks noChangeArrowheads="1"/>
            </p:cNvSpPr>
            <p:nvPr/>
          </p:nvSpPr>
          <p:spPr bwMode="auto">
            <a:xfrm>
              <a:off x="206096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60" name="テキスト ボックス 159"/>
          <p:cNvSpPr txBox="1"/>
          <p:nvPr/>
        </p:nvSpPr>
        <p:spPr>
          <a:xfrm>
            <a:off x="815566" y="6250543"/>
            <a:ext cx="60285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sz="1000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g/ml)</a:t>
            </a:r>
            <a:endParaRPr kumimoji="1"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1" name="テキスト ボックス 160"/>
          <p:cNvSpPr txBox="1"/>
          <p:nvPr/>
        </p:nvSpPr>
        <p:spPr>
          <a:xfrm>
            <a:off x="1542467" y="6116258"/>
            <a:ext cx="64125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L-8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テキスト ボックス 161"/>
          <p:cNvSpPr txBox="1"/>
          <p:nvPr/>
        </p:nvSpPr>
        <p:spPr>
          <a:xfrm>
            <a:off x="2618069" y="6269386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sz="1000" dirty="0" err="1">
                <a:latin typeface="Times New Roman" pitchFamily="18" charset="0"/>
                <a:cs typeface="Times New Roman" pitchFamily="18" charset="0"/>
              </a:rPr>
              <a:t>n</a:t>
            </a:r>
            <a:r>
              <a:rPr kumimoji="1" lang="en-US" altLang="ja-JP" sz="1000" dirty="0" err="1" smtClean="0">
                <a:latin typeface="Times New Roman" pitchFamily="18" charset="0"/>
                <a:cs typeface="Times New Roman" pitchFamily="18" charset="0"/>
              </a:rPr>
              <a:t>g</a:t>
            </a:r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/ml)</a:t>
            </a:r>
            <a:endParaRPr kumimoji="1"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3" name="テキスト ボックス 162"/>
          <p:cNvSpPr txBox="1"/>
          <p:nvPr/>
        </p:nvSpPr>
        <p:spPr>
          <a:xfrm>
            <a:off x="4998731" y="6136003"/>
            <a:ext cx="9505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otal </a:t>
            </a:r>
            <a:r>
              <a:rPr lang="en-US" altLang="ja-JP" sz="14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E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4" name="テキスト ボックス 163"/>
          <p:cNvSpPr txBox="1"/>
          <p:nvPr/>
        </p:nvSpPr>
        <p:spPr>
          <a:xfrm>
            <a:off x="4422667" y="6268625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(</a:t>
            </a:r>
            <a:r>
              <a:rPr lang="en-US" altLang="ja-JP" sz="1000" dirty="0" err="1">
                <a:latin typeface="Times New Roman" pitchFamily="18" charset="0"/>
                <a:cs typeface="Times New Roman" pitchFamily="18" charset="0"/>
              </a:rPr>
              <a:t>n</a:t>
            </a:r>
            <a:r>
              <a:rPr kumimoji="1" lang="en-US" altLang="ja-JP" sz="1000" dirty="0" err="1" smtClean="0">
                <a:latin typeface="Times New Roman" pitchFamily="18" charset="0"/>
                <a:cs typeface="Times New Roman" pitchFamily="18" charset="0"/>
              </a:rPr>
              <a:t>g</a:t>
            </a:r>
            <a:r>
              <a:rPr kumimoji="1" lang="en-US" altLang="ja-JP" sz="1000" dirty="0" smtClean="0">
                <a:latin typeface="Times New Roman" pitchFamily="18" charset="0"/>
                <a:cs typeface="Times New Roman" pitchFamily="18" charset="0"/>
              </a:rPr>
              <a:t>/ml)</a:t>
            </a:r>
            <a:endParaRPr kumimoji="1"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" name="テキスト ボックス 164"/>
          <p:cNvSpPr txBox="1"/>
          <p:nvPr/>
        </p:nvSpPr>
        <p:spPr>
          <a:xfrm>
            <a:off x="3342547" y="6135242"/>
            <a:ext cx="59050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CP</a:t>
            </a:r>
            <a:endParaRPr kumimoji="1" lang="ja-JP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7" name="テキスト ボックス 166"/>
          <p:cNvSpPr txBox="1"/>
          <p:nvPr/>
        </p:nvSpPr>
        <p:spPr>
          <a:xfrm rot="16200000">
            <a:off x="161317" y="7164314"/>
            <a:ext cx="9077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ft  eye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8" name="グループ化 167"/>
          <p:cNvGrpSpPr/>
          <p:nvPr/>
        </p:nvGrpSpPr>
        <p:grpSpPr>
          <a:xfrm>
            <a:off x="1089317" y="6502586"/>
            <a:ext cx="131446" cy="1901072"/>
            <a:chOff x="1089317" y="3094460"/>
            <a:chExt cx="131446" cy="1901072"/>
          </a:xfrm>
        </p:grpSpPr>
        <p:sp>
          <p:nvSpPr>
            <p:cNvPr id="169" name="Rectangle 40"/>
            <p:cNvSpPr>
              <a:spLocks noChangeArrowheads="1"/>
            </p:cNvSpPr>
            <p:nvPr/>
          </p:nvSpPr>
          <p:spPr bwMode="auto">
            <a:xfrm>
              <a:off x="1156643" y="4841644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Rectangle 41"/>
            <p:cNvSpPr>
              <a:spLocks noChangeArrowheads="1"/>
            </p:cNvSpPr>
            <p:nvPr/>
          </p:nvSpPr>
          <p:spPr bwMode="auto">
            <a:xfrm>
              <a:off x="1089317" y="4404848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Rectangle 42"/>
            <p:cNvSpPr>
              <a:spLocks noChangeArrowheads="1"/>
            </p:cNvSpPr>
            <p:nvPr/>
          </p:nvSpPr>
          <p:spPr bwMode="auto">
            <a:xfrm>
              <a:off x="1089317" y="3968052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2" name="Rectangle 43"/>
            <p:cNvSpPr>
              <a:spLocks noChangeArrowheads="1"/>
            </p:cNvSpPr>
            <p:nvPr/>
          </p:nvSpPr>
          <p:spPr bwMode="auto">
            <a:xfrm>
              <a:off x="1089317" y="3531256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Rectangle 44"/>
            <p:cNvSpPr>
              <a:spLocks noChangeArrowheads="1"/>
            </p:cNvSpPr>
            <p:nvPr/>
          </p:nvSpPr>
          <p:spPr bwMode="auto">
            <a:xfrm>
              <a:off x="1089317" y="3094460"/>
              <a:ext cx="13144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87" name="グループ化 186"/>
          <p:cNvGrpSpPr/>
          <p:nvPr/>
        </p:nvGrpSpPr>
        <p:grpSpPr>
          <a:xfrm>
            <a:off x="3068959" y="6549251"/>
            <a:ext cx="1080000" cy="1800000"/>
            <a:chOff x="3078657" y="3608388"/>
            <a:chExt cx="948555" cy="2128838"/>
          </a:xfrm>
        </p:grpSpPr>
        <p:sp>
          <p:nvSpPr>
            <p:cNvPr id="188" name="Freeform 77"/>
            <p:cNvSpPr>
              <a:spLocks noEditPoints="1"/>
            </p:cNvSpPr>
            <p:nvPr/>
          </p:nvSpPr>
          <p:spPr bwMode="auto">
            <a:xfrm>
              <a:off x="3078657" y="3608388"/>
              <a:ext cx="948555" cy="2128838"/>
            </a:xfrm>
            <a:custGeom>
              <a:avLst/>
              <a:gdLst>
                <a:gd name="T0" fmla="*/ 0 w 1529"/>
                <a:gd name="T1" fmla="*/ 6 h 2681"/>
                <a:gd name="T2" fmla="*/ 0 w 1529"/>
                <a:gd name="T3" fmla="*/ 0 h 2681"/>
                <a:gd name="T4" fmla="*/ 6 w 1529"/>
                <a:gd name="T5" fmla="*/ 0 h 2681"/>
                <a:gd name="T6" fmla="*/ 1523 w 1529"/>
                <a:gd name="T7" fmla="*/ 0 h 2681"/>
                <a:gd name="T8" fmla="*/ 1527 w 1529"/>
                <a:gd name="T9" fmla="*/ 0 h 2681"/>
                <a:gd name="T10" fmla="*/ 1529 w 1529"/>
                <a:gd name="T11" fmla="*/ 6 h 2681"/>
                <a:gd name="T12" fmla="*/ 1529 w 1529"/>
                <a:gd name="T13" fmla="*/ 2676 h 2681"/>
                <a:gd name="T14" fmla="*/ 1527 w 1529"/>
                <a:gd name="T15" fmla="*/ 2680 h 2681"/>
                <a:gd name="T16" fmla="*/ 1523 w 1529"/>
                <a:gd name="T17" fmla="*/ 2681 h 2681"/>
                <a:gd name="T18" fmla="*/ 6 w 1529"/>
                <a:gd name="T19" fmla="*/ 2681 h 2681"/>
                <a:gd name="T20" fmla="*/ 0 w 1529"/>
                <a:gd name="T21" fmla="*/ 2680 h 2681"/>
                <a:gd name="T22" fmla="*/ 0 w 1529"/>
                <a:gd name="T23" fmla="*/ 2676 h 2681"/>
                <a:gd name="T24" fmla="*/ 0 w 1529"/>
                <a:gd name="T25" fmla="*/ 6 h 2681"/>
                <a:gd name="T26" fmla="*/ 12 w 1529"/>
                <a:gd name="T27" fmla="*/ 2676 h 2681"/>
                <a:gd name="T28" fmla="*/ 6 w 1529"/>
                <a:gd name="T29" fmla="*/ 2670 h 2681"/>
                <a:gd name="T30" fmla="*/ 1523 w 1529"/>
                <a:gd name="T31" fmla="*/ 2670 h 2681"/>
                <a:gd name="T32" fmla="*/ 1517 w 1529"/>
                <a:gd name="T33" fmla="*/ 2676 h 2681"/>
                <a:gd name="T34" fmla="*/ 1517 w 1529"/>
                <a:gd name="T35" fmla="*/ 6 h 2681"/>
                <a:gd name="T36" fmla="*/ 1523 w 1529"/>
                <a:gd name="T37" fmla="*/ 11 h 2681"/>
                <a:gd name="T38" fmla="*/ 6 w 1529"/>
                <a:gd name="T39" fmla="*/ 11 h 2681"/>
                <a:gd name="T40" fmla="*/ 12 w 1529"/>
                <a:gd name="T41" fmla="*/ 6 h 2681"/>
                <a:gd name="T42" fmla="*/ 12 w 1529"/>
                <a:gd name="T43" fmla="*/ 2676 h 268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529" h="2681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523" y="0"/>
                  </a:lnTo>
                  <a:lnTo>
                    <a:pt x="1527" y="0"/>
                  </a:lnTo>
                  <a:lnTo>
                    <a:pt x="1529" y="6"/>
                  </a:lnTo>
                  <a:lnTo>
                    <a:pt x="1529" y="2676"/>
                  </a:lnTo>
                  <a:lnTo>
                    <a:pt x="1527" y="2680"/>
                  </a:lnTo>
                  <a:lnTo>
                    <a:pt x="1523" y="2681"/>
                  </a:lnTo>
                  <a:lnTo>
                    <a:pt x="6" y="2681"/>
                  </a:lnTo>
                  <a:lnTo>
                    <a:pt x="0" y="2680"/>
                  </a:lnTo>
                  <a:lnTo>
                    <a:pt x="0" y="2676"/>
                  </a:lnTo>
                  <a:lnTo>
                    <a:pt x="0" y="6"/>
                  </a:lnTo>
                  <a:close/>
                  <a:moveTo>
                    <a:pt x="12" y="2676"/>
                  </a:moveTo>
                  <a:lnTo>
                    <a:pt x="6" y="2670"/>
                  </a:lnTo>
                  <a:lnTo>
                    <a:pt x="1523" y="2670"/>
                  </a:lnTo>
                  <a:lnTo>
                    <a:pt x="1517" y="2676"/>
                  </a:lnTo>
                  <a:lnTo>
                    <a:pt x="1517" y="6"/>
                  </a:lnTo>
                  <a:lnTo>
                    <a:pt x="1523" y="11"/>
                  </a:lnTo>
                  <a:lnTo>
                    <a:pt x="6" y="11"/>
                  </a:lnTo>
                  <a:lnTo>
                    <a:pt x="12" y="6"/>
                  </a:lnTo>
                  <a:lnTo>
                    <a:pt x="12" y="2676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89" name="Freeform 78"/>
            <p:cNvSpPr>
              <a:spLocks noEditPoints="1"/>
            </p:cNvSpPr>
            <p:nvPr/>
          </p:nvSpPr>
          <p:spPr bwMode="auto">
            <a:xfrm>
              <a:off x="3170733" y="3930651"/>
              <a:ext cx="128588" cy="1806575"/>
            </a:xfrm>
            <a:custGeom>
              <a:avLst/>
              <a:gdLst>
                <a:gd name="T0" fmla="*/ 0 w 163"/>
                <a:gd name="T1" fmla="*/ 6 h 2276"/>
                <a:gd name="T2" fmla="*/ 0 w 163"/>
                <a:gd name="T3" fmla="*/ 0 h 2276"/>
                <a:gd name="T4" fmla="*/ 5 w 163"/>
                <a:gd name="T5" fmla="*/ 0 h 2276"/>
                <a:gd name="T6" fmla="*/ 157 w 163"/>
                <a:gd name="T7" fmla="*/ 0 h 2276"/>
                <a:gd name="T8" fmla="*/ 161 w 163"/>
                <a:gd name="T9" fmla="*/ 0 h 2276"/>
                <a:gd name="T10" fmla="*/ 163 w 163"/>
                <a:gd name="T11" fmla="*/ 6 h 2276"/>
                <a:gd name="T12" fmla="*/ 163 w 163"/>
                <a:gd name="T13" fmla="*/ 2271 h 2276"/>
                <a:gd name="T14" fmla="*/ 161 w 163"/>
                <a:gd name="T15" fmla="*/ 2275 h 2276"/>
                <a:gd name="T16" fmla="*/ 157 w 163"/>
                <a:gd name="T17" fmla="*/ 2276 h 2276"/>
                <a:gd name="T18" fmla="*/ 5 w 163"/>
                <a:gd name="T19" fmla="*/ 2276 h 2276"/>
                <a:gd name="T20" fmla="*/ 0 w 163"/>
                <a:gd name="T21" fmla="*/ 2275 h 2276"/>
                <a:gd name="T22" fmla="*/ 0 w 163"/>
                <a:gd name="T23" fmla="*/ 2271 h 2276"/>
                <a:gd name="T24" fmla="*/ 0 w 163"/>
                <a:gd name="T25" fmla="*/ 6 h 2276"/>
                <a:gd name="T26" fmla="*/ 11 w 163"/>
                <a:gd name="T27" fmla="*/ 2271 h 2276"/>
                <a:gd name="T28" fmla="*/ 5 w 163"/>
                <a:gd name="T29" fmla="*/ 2265 h 2276"/>
                <a:gd name="T30" fmla="*/ 157 w 163"/>
                <a:gd name="T31" fmla="*/ 2265 h 2276"/>
                <a:gd name="T32" fmla="*/ 151 w 163"/>
                <a:gd name="T33" fmla="*/ 2271 h 2276"/>
                <a:gd name="T34" fmla="*/ 151 w 163"/>
                <a:gd name="T35" fmla="*/ 6 h 2276"/>
                <a:gd name="T36" fmla="*/ 157 w 163"/>
                <a:gd name="T37" fmla="*/ 11 h 2276"/>
                <a:gd name="T38" fmla="*/ 5 w 163"/>
                <a:gd name="T39" fmla="*/ 11 h 2276"/>
                <a:gd name="T40" fmla="*/ 11 w 163"/>
                <a:gd name="T41" fmla="*/ 6 h 2276"/>
                <a:gd name="T42" fmla="*/ 11 w 163"/>
                <a:gd name="T43" fmla="*/ 2271 h 227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63" h="2276">
                  <a:moveTo>
                    <a:pt x="0" y="6"/>
                  </a:moveTo>
                  <a:lnTo>
                    <a:pt x="0" y="0"/>
                  </a:lnTo>
                  <a:lnTo>
                    <a:pt x="5" y="0"/>
                  </a:lnTo>
                  <a:lnTo>
                    <a:pt x="157" y="0"/>
                  </a:lnTo>
                  <a:lnTo>
                    <a:pt x="161" y="0"/>
                  </a:lnTo>
                  <a:lnTo>
                    <a:pt x="163" y="6"/>
                  </a:lnTo>
                  <a:lnTo>
                    <a:pt x="163" y="2271"/>
                  </a:lnTo>
                  <a:lnTo>
                    <a:pt x="161" y="2275"/>
                  </a:lnTo>
                  <a:lnTo>
                    <a:pt x="157" y="2276"/>
                  </a:lnTo>
                  <a:lnTo>
                    <a:pt x="5" y="2276"/>
                  </a:lnTo>
                  <a:lnTo>
                    <a:pt x="0" y="2275"/>
                  </a:lnTo>
                  <a:lnTo>
                    <a:pt x="0" y="2271"/>
                  </a:lnTo>
                  <a:lnTo>
                    <a:pt x="0" y="6"/>
                  </a:lnTo>
                  <a:close/>
                  <a:moveTo>
                    <a:pt x="11" y="2271"/>
                  </a:moveTo>
                  <a:lnTo>
                    <a:pt x="5" y="2265"/>
                  </a:lnTo>
                  <a:lnTo>
                    <a:pt x="157" y="2265"/>
                  </a:lnTo>
                  <a:lnTo>
                    <a:pt x="151" y="2271"/>
                  </a:lnTo>
                  <a:lnTo>
                    <a:pt x="151" y="6"/>
                  </a:lnTo>
                  <a:lnTo>
                    <a:pt x="157" y="11"/>
                  </a:lnTo>
                  <a:lnTo>
                    <a:pt x="5" y="11"/>
                  </a:lnTo>
                  <a:lnTo>
                    <a:pt x="11" y="6"/>
                  </a:lnTo>
                  <a:lnTo>
                    <a:pt x="11" y="2271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0" name="Freeform 79"/>
            <p:cNvSpPr>
              <a:spLocks noEditPoints="1"/>
            </p:cNvSpPr>
            <p:nvPr/>
          </p:nvSpPr>
          <p:spPr bwMode="auto">
            <a:xfrm>
              <a:off x="3470770" y="4586288"/>
              <a:ext cx="130175" cy="1150938"/>
            </a:xfrm>
            <a:custGeom>
              <a:avLst/>
              <a:gdLst>
                <a:gd name="T0" fmla="*/ 0 w 163"/>
                <a:gd name="T1" fmla="*/ 6 h 1451"/>
                <a:gd name="T2" fmla="*/ 0 w 163"/>
                <a:gd name="T3" fmla="*/ 0 h 1451"/>
                <a:gd name="T4" fmla="*/ 6 w 163"/>
                <a:gd name="T5" fmla="*/ 0 h 1451"/>
                <a:gd name="T6" fmla="*/ 157 w 163"/>
                <a:gd name="T7" fmla="*/ 0 h 1451"/>
                <a:gd name="T8" fmla="*/ 161 w 163"/>
                <a:gd name="T9" fmla="*/ 0 h 1451"/>
                <a:gd name="T10" fmla="*/ 163 w 163"/>
                <a:gd name="T11" fmla="*/ 6 h 1451"/>
                <a:gd name="T12" fmla="*/ 163 w 163"/>
                <a:gd name="T13" fmla="*/ 1446 h 1451"/>
                <a:gd name="T14" fmla="*/ 161 w 163"/>
                <a:gd name="T15" fmla="*/ 1450 h 1451"/>
                <a:gd name="T16" fmla="*/ 157 w 163"/>
                <a:gd name="T17" fmla="*/ 1451 h 1451"/>
                <a:gd name="T18" fmla="*/ 6 w 163"/>
                <a:gd name="T19" fmla="*/ 1451 h 1451"/>
                <a:gd name="T20" fmla="*/ 0 w 163"/>
                <a:gd name="T21" fmla="*/ 1450 h 1451"/>
                <a:gd name="T22" fmla="*/ 0 w 163"/>
                <a:gd name="T23" fmla="*/ 1446 h 1451"/>
                <a:gd name="T24" fmla="*/ 0 w 163"/>
                <a:gd name="T25" fmla="*/ 6 h 1451"/>
                <a:gd name="T26" fmla="*/ 11 w 163"/>
                <a:gd name="T27" fmla="*/ 1446 h 1451"/>
                <a:gd name="T28" fmla="*/ 6 w 163"/>
                <a:gd name="T29" fmla="*/ 1440 h 1451"/>
                <a:gd name="T30" fmla="*/ 157 w 163"/>
                <a:gd name="T31" fmla="*/ 1440 h 1451"/>
                <a:gd name="T32" fmla="*/ 152 w 163"/>
                <a:gd name="T33" fmla="*/ 1446 h 1451"/>
                <a:gd name="T34" fmla="*/ 152 w 163"/>
                <a:gd name="T35" fmla="*/ 6 h 1451"/>
                <a:gd name="T36" fmla="*/ 157 w 163"/>
                <a:gd name="T37" fmla="*/ 12 h 1451"/>
                <a:gd name="T38" fmla="*/ 6 w 163"/>
                <a:gd name="T39" fmla="*/ 12 h 1451"/>
                <a:gd name="T40" fmla="*/ 11 w 163"/>
                <a:gd name="T41" fmla="*/ 6 h 1451"/>
                <a:gd name="T42" fmla="*/ 11 w 163"/>
                <a:gd name="T43" fmla="*/ 1446 h 14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63" h="1451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57" y="0"/>
                  </a:lnTo>
                  <a:lnTo>
                    <a:pt x="161" y="0"/>
                  </a:lnTo>
                  <a:lnTo>
                    <a:pt x="163" y="6"/>
                  </a:lnTo>
                  <a:lnTo>
                    <a:pt x="163" y="1446"/>
                  </a:lnTo>
                  <a:lnTo>
                    <a:pt x="161" y="1450"/>
                  </a:lnTo>
                  <a:lnTo>
                    <a:pt x="157" y="1451"/>
                  </a:lnTo>
                  <a:lnTo>
                    <a:pt x="6" y="1451"/>
                  </a:lnTo>
                  <a:lnTo>
                    <a:pt x="0" y="1450"/>
                  </a:lnTo>
                  <a:lnTo>
                    <a:pt x="0" y="1446"/>
                  </a:lnTo>
                  <a:lnTo>
                    <a:pt x="0" y="6"/>
                  </a:lnTo>
                  <a:close/>
                  <a:moveTo>
                    <a:pt x="11" y="1446"/>
                  </a:moveTo>
                  <a:lnTo>
                    <a:pt x="6" y="1440"/>
                  </a:lnTo>
                  <a:lnTo>
                    <a:pt x="157" y="1440"/>
                  </a:lnTo>
                  <a:lnTo>
                    <a:pt x="152" y="1446"/>
                  </a:lnTo>
                  <a:lnTo>
                    <a:pt x="152" y="6"/>
                  </a:lnTo>
                  <a:lnTo>
                    <a:pt x="157" y="12"/>
                  </a:lnTo>
                  <a:lnTo>
                    <a:pt x="6" y="12"/>
                  </a:lnTo>
                  <a:lnTo>
                    <a:pt x="11" y="6"/>
                  </a:lnTo>
                  <a:lnTo>
                    <a:pt x="11" y="1446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91" name="Freeform 80"/>
            <p:cNvSpPr>
              <a:spLocks noEditPoints="1"/>
            </p:cNvSpPr>
            <p:nvPr/>
          </p:nvSpPr>
          <p:spPr bwMode="auto">
            <a:xfrm>
              <a:off x="3770808" y="5483226"/>
              <a:ext cx="130175" cy="254000"/>
            </a:xfrm>
            <a:custGeom>
              <a:avLst/>
              <a:gdLst>
                <a:gd name="T0" fmla="*/ 0 w 163"/>
                <a:gd name="T1" fmla="*/ 6 h 320"/>
                <a:gd name="T2" fmla="*/ 0 w 163"/>
                <a:gd name="T3" fmla="*/ 0 h 320"/>
                <a:gd name="T4" fmla="*/ 6 w 163"/>
                <a:gd name="T5" fmla="*/ 0 h 320"/>
                <a:gd name="T6" fmla="*/ 158 w 163"/>
                <a:gd name="T7" fmla="*/ 0 h 320"/>
                <a:gd name="T8" fmla="*/ 162 w 163"/>
                <a:gd name="T9" fmla="*/ 0 h 320"/>
                <a:gd name="T10" fmla="*/ 163 w 163"/>
                <a:gd name="T11" fmla="*/ 6 h 320"/>
                <a:gd name="T12" fmla="*/ 163 w 163"/>
                <a:gd name="T13" fmla="*/ 315 h 320"/>
                <a:gd name="T14" fmla="*/ 162 w 163"/>
                <a:gd name="T15" fmla="*/ 319 h 320"/>
                <a:gd name="T16" fmla="*/ 158 w 163"/>
                <a:gd name="T17" fmla="*/ 320 h 320"/>
                <a:gd name="T18" fmla="*/ 6 w 163"/>
                <a:gd name="T19" fmla="*/ 320 h 320"/>
                <a:gd name="T20" fmla="*/ 0 w 163"/>
                <a:gd name="T21" fmla="*/ 319 h 320"/>
                <a:gd name="T22" fmla="*/ 0 w 163"/>
                <a:gd name="T23" fmla="*/ 315 h 320"/>
                <a:gd name="T24" fmla="*/ 0 w 163"/>
                <a:gd name="T25" fmla="*/ 6 h 320"/>
                <a:gd name="T26" fmla="*/ 12 w 163"/>
                <a:gd name="T27" fmla="*/ 315 h 320"/>
                <a:gd name="T28" fmla="*/ 6 w 163"/>
                <a:gd name="T29" fmla="*/ 309 h 320"/>
                <a:gd name="T30" fmla="*/ 158 w 163"/>
                <a:gd name="T31" fmla="*/ 309 h 320"/>
                <a:gd name="T32" fmla="*/ 152 w 163"/>
                <a:gd name="T33" fmla="*/ 315 h 320"/>
                <a:gd name="T34" fmla="*/ 152 w 163"/>
                <a:gd name="T35" fmla="*/ 6 h 320"/>
                <a:gd name="T36" fmla="*/ 158 w 163"/>
                <a:gd name="T37" fmla="*/ 11 h 320"/>
                <a:gd name="T38" fmla="*/ 6 w 163"/>
                <a:gd name="T39" fmla="*/ 11 h 320"/>
                <a:gd name="T40" fmla="*/ 12 w 163"/>
                <a:gd name="T41" fmla="*/ 6 h 320"/>
                <a:gd name="T42" fmla="*/ 12 w 163"/>
                <a:gd name="T43" fmla="*/ 315 h 3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63" h="320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58" y="0"/>
                  </a:lnTo>
                  <a:lnTo>
                    <a:pt x="162" y="0"/>
                  </a:lnTo>
                  <a:lnTo>
                    <a:pt x="163" y="6"/>
                  </a:lnTo>
                  <a:lnTo>
                    <a:pt x="163" y="315"/>
                  </a:lnTo>
                  <a:lnTo>
                    <a:pt x="162" y="319"/>
                  </a:lnTo>
                  <a:lnTo>
                    <a:pt x="158" y="320"/>
                  </a:lnTo>
                  <a:lnTo>
                    <a:pt x="6" y="320"/>
                  </a:lnTo>
                  <a:lnTo>
                    <a:pt x="0" y="319"/>
                  </a:lnTo>
                  <a:lnTo>
                    <a:pt x="0" y="315"/>
                  </a:lnTo>
                  <a:lnTo>
                    <a:pt x="0" y="6"/>
                  </a:lnTo>
                  <a:close/>
                  <a:moveTo>
                    <a:pt x="12" y="315"/>
                  </a:moveTo>
                  <a:lnTo>
                    <a:pt x="6" y="309"/>
                  </a:lnTo>
                  <a:lnTo>
                    <a:pt x="158" y="309"/>
                  </a:lnTo>
                  <a:lnTo>
                    <a:pt x="152" y="315"/>
                  </a:lnTo>
                  <a:lnTo>
                    <a:pt x="152" y="6"/>
                  </a:lnTo>
                  <a:lnTo>
                    <a:pt x="158" y="11"/>
                  </a:lnTo>
                  <a:lnTo>
                    <a:pt x="6" y="11"/>
                  </a:lnTo>
                  <a:lnTo>
                    <a:pt x="12" y="6"/>
                  </a:lnTo>
                  <a:lnTo>
                    <a:pt x="12" y="315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192" name="グループ化 191"/>
          <p:cNvGrpSpPr/>
          <p:nvPr/>
        </p:nvGrpSpPr>
        <p:grpSpPr>
          <a:xfrm>
            <a:off x="2745983" y="6512668"/>
            <a:ext cx="256480" cy="1910668"/>
            <a:chOff x="2710358" y="3104542"/>
            <a:chExt cx="256480" cy="1910668"/>
          </a:xfrm>
        </p:grpSpPr>
        <p:sp>
          <p:nvSpPr>
            <p:cNvPr id="193" name="Rectangle 86"/>
            <p:cNvSpPr>
              <a:spLocks noChangeArrowheads="1"/>
            </p:cNvSpPr>
            <p:nvPr/>
          </p:nvSpPr>
          <p:spPr bwMode="auto">
            <a:xfrm>
              <a:off x="2902445" y="486132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4" name="Rectangle 87"/>
            <p:cNvSpPr>
              <a:spLocks noChangeArrowheads="1"/>
            </p:cNvSpPr>
            <p:nvPr/>
          </p:nvSpPr>
          <p:spPr bwMode="auto">
            <a:xfrm>
              <a:off x="2773858" y="4641727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5" name="Rectangle 88"/>
            <p:cNvSpPr>
              <a:spLocks noChangeArrowheads="1"/>
            </p:cNvSpPr>
            <p:nvPr/>
          </p:nvSpPr>
          <p:spPr bwMode="auto">
            <a:xfrm>
              <a:off x="2773858" y="4422129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6" name="Rectangle 89"/>
            <p:cNvSpPr>
              <a:spLocks noChangeArrowheads="1"/>
            </p:cNvSpPr>
            <p:nvPr/>
          </p:nvSpPr>
          <p:spPr bwMode="auto">
            <a:xfrm>
              <a:off x="2773858" y="4202531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6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7" name="Rectangle 90"/>
            <p:cNvSpPr>
              <a:spLocks noChangeArrowheads="1"/>
            </p:cNvSpPr>
            <p:nvPr/>
          </p:nvSpPr>
          <p:spPr bwMode="auto">
            <a:xfrm>
              <a:off x="2773858" y="3982933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8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8" name="Rectangle 91"/>
            <p:cNvSpPr>
              <a:spLocks noChangeArrowheads="1"/>
            </p:cNvSpPr>
            <p:nvPr/>
          </p:nvSpPr>
          <p:spPr bwMode="auto">
            <a:xfrm>
              <a:off x="2710358" y="3763335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9" name="Rectangle 92"/>
            <p:cNvSpPr>
              <a:spLocks noChangeArrowheads="1"/>
            </p:cNvSpPr>
            <p:nvPr/>
          </p:nvSpPr>
          <p:spPr bwMode="auto">
            <a:xfrm>
              <a:off x="2710358" y="3543737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2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0" name="Rectangle 93"/>
            <p:cNvSpPr>
              <a:spLocks noChangeArrowheads="1"/>
            </p:cNvSpPr>
            <p:nvPr/>
          </p:nvSpPr>
          <p:spPr bwMode="auto">
            <a:xfrm>
              <a:off x="2710358" y="3324139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4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1" name="Rectangle 94"/>
            <p:cNvSpPr>
              <a:spLocks noChangeArrowheads="1"/>
            </p:cNvSpPr>
            <p:nvPr/>
          </p:nvSpPr>
          <p:spPr bwMode="auto">
            <a:xfrm>
              <a:off x="2710358" y="3104542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6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2" name="グループ化 201"/>
          <p:cNvGrpSpPr/>
          <p:nvPr/>
        </p:nvGrpSpPr>
        <p:grpSpPr>
          <a:xfrm>
            <a:off x="1340768" y="8399512"/>
            <a:ext cx="878189" cy="153888"/>
            <a:chOff x="1339873" y="2793521"/>
            <a:chExt cx="878189" cy="153888"/>
          </a:xfrm>
        </p:grpSpPr>
        <p:sp>
          <p:nvSpPr>
            <p:cNvPr id="203" name="Rectangle 21"/>
            <p:cNvSpPr>
              <a:spLocks noChangeArrowheads="1"/>
            </p:cNvSpPr>
            <p:nvPr/>
          </p:nvSpPr>
          <p:spPr bwMode="auto">
            <a:xfrm>
              <a:off x="1339873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Rectangle 22"/>
            <p:cNvSpPr>
              <a:spLocks noChangeArrowheads="1"/>
            </p:cNvSpPr>
            <p:nvPr/>
          </p:nvSpPr>
          <p:spPr bwMode="auto">
            <a:xfrm>
              <a:off x="170092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Rectangle 23"/>
            <p:cNvSpPr>
              <a:spLocks noChangeArrowheads="1"/>
            </p:cNvSpPr>
            <p:nvPr/>
          </p:nvSpPr>
          <p:spPr bwMode="auto">
            <a:xfrm>
              <a:off x="206096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06" name="グループ化 205"/>
          <p:cNvGrpSpPr/>
          <p:nvPr/>
        </p:nvGrpSpPr>
        <p:grpSpPr>
          <a:xfrm>
            <a:off x="3167879" y="8398751"/>
            <a:ext cx="878189" cy="153888"/>
            <a:chOff x="1339873" y="2793521"/>
            <a:chExt cx="878189" cy="153888"/>
          </a:xfrm>
        </p:grpSpPr>
        <p:sp>
          <p:nvSpPr>
            <p:cNvPr id="207" name="Rectangle 21"/>
            <p:cNvSpPr>
              <a:spLocks noChangeArrowheads="1"/>
            </p:cNvSpPr>
            <p:nvPr/>
          </p:nvSpPr>
          <p:spPr bwMode="auto">
            <a:xfrm>
              <a:off x="1339873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8" name="Rectangle 22"/>
            <p:cNvSpPr>
              <a:spLocks noChangeArrowheads="1"/>
            </p:cNvSpPr>
            <p:nvPr/>
          </p:nvSpPr>
          <p:spPr bwMode="auto">
            <a:xfrm>
              <a:off x="170092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9" name="Rectangle 23"/>
            <p:cNvSpPr>
              <a:spLocks noChangeArrowheads="1"/>
            </p:cNvSpPr>
            <p:nvPr/>
          </p:nvSpPr>
          <p:spPr bwMode="auto">
            <a:xfrm>
              <a:off x="206096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0" name="グループ化 209"/>
          <p:cNvGrpSpPr/>
          <p:nvPr/>
        </p:nvGrpSpPr>
        <p:grpSpPr>
          <a:xfrm>
            <a:off x="4968079" y="8398751"/>
            <a:ext cx="878189" cy="153888"/>
            <a:chOff x="1339873" y="2793521"/>
            <a:chExt cx="878189" cy="153888"/>
          </a:xfrm>
        </p:grpSpPr>
        <p:sp>
          <p:nvSpPr>
            <p:cNvPr id="211" name="Rectangle 21"/>
            <p:cNvSpPr>
              <a:spLocks noChangeArrowheads="1"/>
            </p:cNvSpPr>
            <p:nvPr/>
          </p:nvSpPr>
          <p:spPr bwMode="auto">
            <a:xfrm>
              <a:off x="1339873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2" name="Rectangle 22"/>
            <p:cNvSpPr>
              <a:spLocks noChangeArrowheads="1"/>
            </p:cNvSpPr>
            <p:nvPr/>
          </p:nvSpPr>
          <p:spPr bwMode="auto">
            <a:xfrm>
              <a:off x="170092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w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3" name="Rectangle 23"/>
            <p:cNvSpPr>
              <a:spLocks noChangeArrowheads="1"/>
            </p:cNvSpPr>
            <p:nvPr/>
          </p:nvSpPr>
          <p:spPr bwMode="auto">
            <a:xfrm>
              <a:off x="2060968" y="2793521"/>
              <a:ext cx="15709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altLang="ja-JP" sz="1000" b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r>
                <a:rPr kumimoji="1" lang="ja-JP" altLang="ja-JP" sz="10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w</a:t>
              </a:r>
              <a:endParaRPr kumimoji="1" lang="ja-JP" altLang="ja-JP" sz="18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14" name="グループ化 213"/>
          <p:cNvGrpSpPr/>
          <p:nvPr/>
        </p:nvGrpSpPr>
        <p:grpSpPr>
          <a:xfrm>
            <a:off x="1257005" y="6560926"/>
            <a:ext cx="1080000" cy="1800000"/>
            <a:chOff x="1066801" y="5519738"/>
            <a:chExt cx="858838" cy="1352550"/>
          </a:xfrm>
        </p:grpSpPr>
        <p:sp>
          <p:nvSpPr>
            <p:cNvPr id="215" name="Freeform 103"/>
            <p:cNvSpPr>
              <a:spLocks noEditPoints="1"/>
            </p:cNvSpPr>
            <p:nvPr/>
          </p:nvSpPr>
          <p:spPr bwMode="auto">
            <a:xfrm>
              <a:off x="1066801" y="5519738"/>
              <a:ext cx="858838" cy="1352550"/>
            </a:xfrm>
            <a:custGeom>
              <a:avLst/>
              <a:gdLst>
                <a:gd name="T0" fmla="*/ 0 w 1446"/>
                <a:gd name="T1" fmla="*/ 6 h 1703"/>
                <a:gd name="T2" fmla="*/ 0 w 1446"/>
                <a:gd name="T3" fmla="*/ 0 h 1703"/>
                <a:gd name="T4" fmla="*/ 6 w 1446"/>
                <a:gd name="T5" fmla="*/ 0 h 1703"/>
                <a:gd name="T6" fmla="*/ 1440 w 1446"/>
                <a:gd name="T7" fmla="*/ 0 h 1703"/>
                <a:gd name="T8" fmla="*/ 1444 w 1446"/>
                <a:gd name="T9" fmla="*/ 0 h 1703"/>
                <a:gd name="T10" fmla="*/ 1446 w 1446"/>
                <a:gd name="T11" fmla="*/ 6 h 1703"/>
                <a:gd name="T12" fmla="*/ 1446 w 1446"/>
                <a:gd name="T13" fmla="*/ 1698 h 1703"/>
                <a:gd name="T14" fmla="*/ 1444 w 1446"/>
                <a:gd name="T15" fmla="*/ 1701 h 1703"/>
                <a:gd name="T16" fmla="*/ 1440 w 1446"/>
                <a:gd name="T17" fmla="*/ 1703 h 1703"/>
                <a:gd name="T18" fmla="*/ 6 w 1446"/>
                <a:gd name="T19" fmla="*/ 1703 h 1703"/>
                <a:gd name="T20" fmla="*/ 0 w 1446"/>
                <a:gd name="T21" fmla="*/ 1701 h 1703"/>
                <a:gd name="T22" fmla="*/ 0 w 1446"/>
                <a:gd name="T23" fmla="*/ 1698 h 1703"/>
                <a:gd name="T24" fmla="*/ 0 w 1446"/>
                <a:gd name="T25" fmla="*/ 6 h 1703"/>
                <a:gd name="T26" fmla="*/ 11 w 1446"/>
                <a:gd name="T27" fmla="*/ 1698 h 1703"/>
                <a:gd name="T28" fmla="*/ 6 w 1446"/>
                <a:gd name="T29" fmla="*/ 1692 h 1703"/>
                <a:gd name="T30" fmla="*/ 1440 w 1446"/>
                <a:gd name="T31" fmla="*/ 1692 h 1703"/>
                <a:gd name="T32" fmla="*/ 1434 w 1446"/>
                <a:gd name="T33" fmla="*/ 1698 h 1703"/>
                <a:gd name="T34" fmla="*/ 1434 w 1446"/>
                <a:gd name="T35" fmla="*/ 6 h 1703"/>
                <a:gd name="T36" fmla="*/ 1440 w 1446"/>
                <a:gd name="T37" fmla="*/ 11 h 1703"/>
                <a:gd name="T38" fmla="*/ 6 w 1446"/>
                <a:gd name="T39" fmla="*/ 11 h 1703"/>
                <a:gd name="T40" fmla="*/ 11 w 1446"/>
                <a:gd name="T41" fmla="*/ 6 h 1703"/>
                <a:gd name="T42" fmla="*/ 11 w 1446"/>
                <a:gd name="T43" fmla="*/ 1698 h 17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446" h="1703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440" y="0"/>
                  </a:lnTo>
                  <a:lnTo>
                    <a:pt x="1444" y="0"/>
                  </a:lnTo>
                  <a:lnTo>
                    <a:pt x="1446" y="6"/>
                  </a:lnTo>
                  <a:lnTo>
                    <a:pt x="1446" y="1698"/>
                  </a:lnTo>
                  <a:lnTo>
                    <a:pt x="1444" y="1701"/>
                  </a:lnTo>
                  <a:lnTo>
                    <a:pt x="1440" y="1703"/>
                  </a:lnTo>
                  <a:lnTo>
                    <a:pt x="6" y="1703"/>
                  </a:lnTo>
                  <a:lnTo>
                    <a:pt x="0" y="1701"/>
                  </a:lnTo>
                  <a:lnTo>
                    <a:pt x="0" y="1698"/>
                  </a:lnTo>
                  <a:lnTo>
                    <a:pt x="0" y="6"/>
                  </a:lnTo>
                  <a:close/>
                  <a:moveTo>
                    <a:pt x="11" y="1698"/>
                  </a:moveTo>
                  <a:lnTo>
                    <a:pt x="6" y="1692"/>
                  </a:lnTo>
                  <a:lnTo>
                    <a:pt x="1440" y="1692"/>
                  </a:lnTo>
                  <a:lnTo>
                    <a:pt x="1434" y="1698"/>
                  </a:lnTo>
                  <a:lnTo>
                    <a:pt x="1434" y="6"/>
                  </a:lnTo>
                  <a:lnTo>
                    <a:pt x="1440" y="11"/>
                  </a:lnTo>
                  <a:lnTo>
                    <a:pt x="6" y="11"/>
                  </a:lnTo>
                  <a:lnTo>
                    <a:pt x="11" y="6"/>
                  </a:lnTo>
                  <a:lnTo>
                    <a:pt x="11" y="1698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6" name="Freeform 104"/>
            <p:cNvSpPr>
              <a:spLocks noEditPoints="1"/>
            </p:cNvSpPr>
            <p:nvPr/>
          </p:nvSpPr>
          <p:spPr bwMode="auto">
            <a:xfrm>
              <a:off x="1152525" y="5613400"/>
              <a:ext cx="122238" cy="1258887"/>
            </a:xfrm>
            <a:custGeom>
              <a:avLst/>
              <a:gdLst>
                <a:gd name="T0" fmla="*/ 0 w 154"/>
                <a:gd name="T1" fmla="*/ 6 h 1586"/>
                <a:gd name="T2" fmla="*/ 0 w 154"/>
                <a:gd name="T3" fmla="*/ 0 h 1586"/>
                <a:gd name="T4" fmla="*/ 6 w 154"/>
                <a:gd name="T5" fmla="*/ 0 h 1586"/>
                <a:gd name="T6" fmla="*/ 148 w 154"/>
                <a:gd name="T7" fmla="*/ 0 h 1586"/>
                <a:gd name="T8" fmla="*/ 152 w 154"/>
                <a:gd name="T9" fmla="*/ 0 h 1586"/>
                <a:gd name="T10" fmla="*/ 154 w 154"/>
                <a:gd name="T11" fmla="*/ 6 h 1586"/>
                <a:gd name="T12" fmla="*/ 154 w 154"/>
                <a:gd name="T13" fmla="*/ 1581 h 1586"/>
                <a:gd name="T14" fmla="*/ 152 w 154"/>
                <a:gd name="T15" fmla="*/ 1584 h 1586"/>
                <a:gd name="T16" fmla="*/ 148 w 154"/>
                <a:gd name="T17" fmla="*/ 1586 h 1586"/>
                <a:gd name="T18" fmla="*/ 6 w 154"/>
                <a:gd name="T19" fmla="*/ 1586 h 1586"/>
                <a:gd name="T20" fmla="*/ 0 w 154"/>
                <a:gd name="T21" fmla="*/ 1584 h 1586"/>
                <a:gd name="T22" fmla="*/ 0 w 154"/>
                <a:gd name="T23" fmla="*/ 1581 h 1586"/>
                <a:gd name="T24" fmla="*/ 0 w 154"/>
                <a:gd name="T25" fmla="*/ 6 h 1586"/>
                <a:gd name="T26" fmla="*/ 12 w 154"/>
                <a:gd name="T27" fmla="*/ 1581 h 1586"/>
                <a:gd name="T28" fmla="*/ 6 w 154"/>
                <a:gd name="T29" fmla="*/ 1575 h 1586"/>
                <a:gd name="T30" fmla="*/ 148 w 154"/>
                <a:gd name="T31" fmla="*/ 1575 h 1586"/>
                <a:gd name="T32" fmla="*/ 143 w 154"/>
                <a:gd name="T33" fmla="*/ 1581 h 1586"/>
                <a:gd name="T34" fmla="*/ 143 w 154"/>
                <a:gd name="T35" fmla="*/ 6 h 1586"/>
                <a:gd name="T36" fmla="*/ 148 w 154"/>
                <a:gd name="T37" fmla="*/ 12 h 1586"/>
                <a:gd name="T38" fmla="*/ 6 w 154"/>
                <a:gd name="T39" fmla="*/ 12 h 1586"/>
                <a:gd name="T40" fmla="*/ 12 w 154"/>
                <a:gd name="T41" fmla="*/ 6 h 1586"/>
                <a:gd name="T42" fmla="*/ 12 w 154"/>
                <a:gd name="T43" fmla="*/ 1581 h 15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54" h="1586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48" y="0"/>
                  </a:lnTo>
                  <a:lnTo>
                    <a:pt x="152" y="0"/>
                  </a:lnTo>
                  <a:lnTo>
                    <a:pt x="154" y="6"/>
                  </a:lnTo>
                  <a:lnTo>
                    <a:pt x="154" y="1581"/>
                  </a:lnTo>
                  <a:lnTo>
                    <a:pt x="152" y="1584"/>
                  </a:lnTo>
                  <a:lnTo>
                    <a:pt x="148" y="1586"/>
                  </a:lnTo>
                  <a:lnTo>
                    <a:pt x="6" y="1586"/>
                  </a:lnTo>
                  <a:lnTo>
                    <a:pt x="0" y="1584"/>
                  </a:lnTo>
                  <a:lnTo>
                    <a:pt x="0" y="1581"/>
                  </a:lnTo>
                  <a:lnTo>
                    <a:pt x="0" y="6"/>
                  </a:lnTo>
                  <a:close/>
                  <a:moveTo>
                    <a:pt x="12" y="1581"/>
                  </a:moveTo>
                  <a:lnTo>
                    <a:pt x="6" y="1575"/>
                  </a:lnTo>
                  <a:lnTo>
                    <a:pt x="148" y="1575"/>
                  </a:lnTo>
                  <a:lnTo>
                    <a:pt x="143" y="1581"/>
                  </a:lnTo>
                  <a:lnTo>
                    <a:pt x="143" y="6"/>
                  </a:lnTo>
                  <a:lnTo>
                    <a:pt x="148" y="12"/>
                  </a:lnTo>
                  <a:lnTo>
                    <a:pt x="6" y="12"/>
                  </a:lnTo>
                  <a:lnTo>
                    <a:pt x="12" y="6"/>
                  </a:lnTo>
                  <a:lnTo>
                    <a:pt x="12" y="1581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7" name="Freeform 105"/>
            <p:cNvSpPr>
              <a:spLocks noEditPoints="1"/>
            </p:cNvSpPr>
            <p:nvPr/>
          </p:nvSpPr>
          <p:spPr bwMode="auto">
            <a:xfrm>
              <a:off x="1436688" y="6324600"/>
              <a:ext cx="123825" cy="547687"/>
            </a:xfrm>
            <a:custGeom>
              <a:avLst/>
              <a:gdLst>
                <a:gd name="T0" fmla="*/ 0 w 155"/>
                <a:gd name="T1" fmla="*/ 6 h 689"/>
                <a:gd name="T2" fmla="*/ 0 w 155"/>
                <a:gd name="T3" fmla="*/ 0 h 689"/>
                <a:gd name="T4" fmla="*/ 5 w 155"/>
                <a:gd name="T5" fmla="*/ 0 h 689"/>
                <a:gd name="T6" fmla="*/ 149 w 155"/>
                <a:gd name="T7" fmla="*/ 0 h 689"/>
                <a:gd name="T8" fmla="*/ 153 w 155"/>
                <a:gd name="T9" fmla="*/ 0 h 689"/>
                <a:gd name="T10" fmla="*/ 155 w 155"/>
                <a:gd name="T11" fmla="*/ 6 h 689"/>
                <a:gd name="T12" fmla="*/ 155 w 155"/>
                <a:gd name="T13" fmla="*/ 684 h 689"/>
                <a:gd name="T14" fmla="*/ 153 w 155"/>
                <a:gd name="T15" fmla="*/ 687 h 689"/>
                <a:gd name="T16" fmla="*/ 149 w 155"/>
                <a:gd name="T17" fmla="*/ 689 h 689"/>
                <a:gd name="T18" fmla="*/ 5 w 155"/>
                <a:gd name="T19" fmla="*/ 689 h 689"/>
                <a:gd name="T20" fmla="*/ 0 w 155"/>
                <a:gd name="T21" fmla="*/ 687 h 689"/>
                <a:gd name="T22" fmla="*/ 0 w 155"/>
                <a:gd name="T23" fmla="*/ 684 h 689"/>
                <a:gd name="T24" fmla="*/ 0 w 155"/>
                <a:gd name="T25" fmla="*/ 6 h 689"/>
                <a:gd name="T26" fmla="*/ 11 w 155"/>
                <a:gd name="T27" fmla="*/ 684 h 689"/>
                <a:gd name="T28" fmla="*/ 5 w 155"/>
                <a:gd name="T29" fmla="*/ 678 h 689"/>
                <a:gd name="T30" fmla="*/ 149 w 155"/>
                <a:gd name="T31" fmla="*/ 678 h 689"/>
                <a:gd name="T32" fmla="*/ 144 w 155"/>
                <a:gd name="T33" fmla="*/ 684 h 689"/>
                <a:gd name="T34" fmla="*/ 144 w 155"/>
                <a:gd name="T35" fmla="*/ 6 h 689"/>
                <a:gd name="T36" fmla="*/ 149 w 155"/>
                <a:gd name="T37" fmla="*/ 11 h 689"/>
                <a:gd name="T38" fmla="*/ 5 w 155"/>
                <a:gd name="T39" fmla="*/ 11 h 689"/>
                <a:gd name="T40" fmla="*/ 11 w 155"/>
                <a:gd name="T41" fmla="*/ 6 h 689"/>
                <a:gd name="T42" fmla="*/ 11 w 155"/>
                <a:gd name="T43" fmla="*/ 684 h 68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55" h="689">
                  <a:moveTo>
                    <a:pt x="0" y="6"/>
                  </a:moveTo>
                  <a:lnTo>
                    <a:pt x="0" y="0"/>
                  </a:lnTo>
                  <a:lnTo>
                    <a:pt x="5" y="0"/>
                  </a:lnTo>
                  <a:lnTo>
                    <a:pt x="149" y="0"/>
                  </a:lnTo>
                  <a:lnTo>
                    <a:pt x="153" y="0"/>
                  </a:lnTo>
                  <a:lnTo>
                    <a:pt x="155" y="6"/>
                  </a:lnTo>
                  <a:lnTo>
                    <a:pt x="155" y="684"/>
                  </a:lnTo>
                  <a:lnTo>
                    <a:pt x="153" y="687"/>
                  </a:lnTo>
                  <a:lnTo>
                    <a:pt x="149" y="689"/>
                  </a:lnTo>
                  <a:lnTo>
                    <a:pt x="5" y="689"/>
                  </a:lnTo>
                  <a:lnTo>
                    <a:pt x="0" y="687"/>
                  </a:lnTo>
                  <a:lnTo>
                    <a:pt x="0" y="684"/>
                  </a:lnTo>
                  <a:lnTo>
                    <a:pt x="0" y="6"/>
                  </a:lnTo>
                  <a:close/>
                  <a:moveTo>
                    <a:pt x="11" y="684"/>
                  </a:moveTo>
                  <a:lnTo>
                    <a:pt x="5" y="678"/>
                  </a:lnTo>
                  <a:lnTo>
                    <a:pt x="149" y="678"/>
                  </a:lnTo>
                  <a:lnTo>
                    <a:pt x="144" y="684"/>
                  </a:lnTo>
                  <a:lnTo>
                    <a:pt x="144" y="6"/>
                  </a:lnTo>
                  <a:lnTo>
                    <a:pt x="149" y="11"/>
                  </a:lnTo>
                  <a:lnTo>
                    <a:pt x="5" y="11"/>
                  </a:lnTo>
                  <a:lnTo>
                    <a:pt x="11" y="6"/>
                  </a:lnTo>
                  <a:lnTo>
                    <a:pt x="11" y="684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18" name="Freeform 106"/>
            <p:cNvSpPr>
              <a:spLocks noEditPoints="1"/>
            </p:cNvSpPr>
            <p:nvPr/>
          </p:nvSpPr>
          <p:spPr bwMode="auto">
            <a:xfrm>
              <a:off x="1720850" y="6780213"/>
              <a:ext cx="123825" cy="92075"/>
            </a:xfrm>
            <a:custGeom>
              <a:avLst/>
              <a:gdLst>
                <a:gd name="T0" fmla="*/ 0 w 155"/>
                <a:gd name="T1" fmla="*/ 6 h 117"/>
                <a:gd name="T2" fmla="*/ 0 w 155"/>
                <a:gd name="T3" fmla="*/ 0 h 117"/>
                <a:gd name="T4" fmla="*/ 6 w 155"/>
                <a:gd name="T5" fmla="*/ 0 h 117"/>
                <a:gd name="T6" fmla="*/ 150 w 155"/>
                <a:gd name="T7" fmla="*/ 0 h 117"/>
                <a:gd name="T8" fmla="*/ 153 w 155"/>
                <a:gd name="T9" fmla="*/ 0 h 117"/>
                <a:gd name="T10" fmla="*/ 155 w 155"/>
                <a:gd name="T11" fmla="*/ 6 h 117"/>
                <a:gd name="T12" fmla="*/ 155 w 155"/>
                <a:gd name="T13" fmla="*/ 112 h 117"/>
                <a:gd name="T14" fmla="*/ 153 w 155"/>
                <a:gd name="T15" fmla="*/ 115 h 117"/>
                <a:gd name="T16" fmla="*/ 150 w 155"/>
                <a:gd name="T17" fmla="*/ 117 h 117"/>
                <a:gd name="T18" fmla="*/ 6 w 155"/>
                <a:gd name="T19" fmla="*/ 117 h 117"/>
                <a:gd name="T20" fmla="*/ 0 w 155"/>
                <a:gd name="T21" fmla="*/ 115 h 117"/>
                <a:gd name="T22" fmla="*/ 0 w 155"/>
                <a:gd name="T23" fmla="*/ 112 h 117"/>
                <a:gd name="T24" fmla="*/ 0 w 155"/>
                <a:gd name="T25" fmla="*/ 6 h 117"/>
                <a:gd name="T26" fmla="*/ 11 w 155"/>
                <a:gd name="T27" fmla="*/ 112 h 117"/>
                <a:gd name="T28" fmla="*/ 6 w 155"/>
                <a:gd name="T29" fmla="*/ 106 h 117"/>
                <a:gd name="T30" fmla="*/ 150 w 155"/>
                <a:gd name="T31" fmla="*/ 106 h 117"/>
                <a:gd name="T32" fmla="*/ 144 w 155"/>
                <a:gd name="T33" fmla="*/ 112 h 117"/>
                <a:gd name="T34" fmla="*/ 144 w 155"/>
                <a:gd name="T35" fmla="*/ 6 h 117"/>
                <a:gd name="T36" fmla="*/ 150 w 155"/>
                <a:gd name="T37" fmla="*/ 12 h 117"/>
                <a:gd name="T38" fmla="*/ 6 w 155"/>
                <a:gd name="T39" fmla="*/ 12 h 117"/>
                <a:gd name="T40" fmla="*/ 11 w 155"/>
                <a:gd name="T41" fmla="*/ 6 h 117"/>
                <a:gd name="T42" fmla="*/ 11 w 155"/>
                <a:gd name="T43" fmla="*/ 112 h 1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55" h="117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50" y="0"/>
                  </a:lnTo>
                  <a:lnTo>
                    <a:pt x="153" y="0"/>
                  </a:lnTo>
                  <a:lnTo>
                    <a:pt x="155" y="6"/>
                  </a:lnTo>
                  <a:lnTo>
                    <a:pt x="155" y="112"/>
                  </a:lnTo>
                  <a:lnTo>
                    <a:pt x="153" y="115"/>
                  </a:lnTo>
                  <a:lnTo>
                    <a:pt x="150" y="117"/>
                  </a:lnTo>
                  <a:lnTo>
                    <a:pt x="6" y="117"/>
                  </a:lnTo>
                  <a:lnTo>
                    <a:pt x="0" y="115"/>
                  </a:lnTo>
                  <a:lnTo>
                    <a:pt x="0" y="112"/>
                  </a:lnTo>
                  <a:lnTo>
                    <a:pt x="0" y="6"/>
                  </a:lnTo>
                  <a:close/>
                  <a:moveTo>
                    <a:pt x="11" y="112"/>
                  </a:moveTo>
                  <a:lnTo>
                    <a:pt x="6" y="106"/>
                  </a:lnTo>
                  <a:lnTo>
                    <a:pt x="150" y="106"/>
                  </a:lnTo>
                  <a:lnTo>
                    <a:pt x="144" y="112"/>
                  </a:lnTo>
                  <a:lnTo>
                    <a:pt x="144" y="6"/>
                  </a:lnTo>
                  <a:lnTo>
                    <a:pt x="150" y="12"/>
                  </a:lnTo>
                  <a:lnTo>
                    <a:pt x="6" y="12"/>
                  </a:lnTo>
                  <a:lnTo>
                    <a:pt x="11" y="6"/>
                  </a:lnTo>
                  <a:lnTo>
                    <a:pt x="11" y="112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32" name="グループ化 231"/>
          <p:cNvGrpSpPr/>
          <p:nvPr/>
        </p:nvGrpSpPr>
        <p:grpSpPr>
          <a:xfrm>
            <a:off x="4844652" y="6549251"/>
            <a:ext cx="1080000" cy="1800000"/>
            <a:chOff x="2898776" y="6345238"/>
            <a:chExt cx="1053563" cy="1608138"/>
          </a:xfrm>
        </p:grpSpPr>
        <p:sp>
          <p:nvSpPr>
            <p:cNvPr id="233" name="Freeform 149"/>
            <p:cNvSpPr>
              <a:spLocks noEditPoints="1"/>
            </p:cNvSpPr>
            <p:nvPr/>
          </p:nvSpPr>
          <p:spPr bwMode="auto">
            <a:xfrm>
              <a:off x="2898776" y="6345238"/>
              <a:ext cx="1053563" cy="1608138"/>
            </a:xfrm>
            <a:custGeom>
              <a:avLst/>
              <a:gdLst>
                <a:gd name="T0" fmla="*/ 0 w 1745"/>
                <a:gd name="T1" fmla="*/ 6 h 2025"/>
                <a:gd name="T2" fmla="*/ 0 w 1745"/>
                <a:gd name="T3" fmla="*/ 0 h 2025"/>
                <a:gd name="T4" fmla="*/ 6 w 1745"/>
                <a:gd name="T5" fmla="*/ 0 h 2025"/>
                <a:gd name="T6" fmla="*/ 1739 w 1745"/>
                <a:gd name="T7" fmla="*/ 0 h 2025"/>
                <a:gd name="T8" fmla="*/ 1743 w 1745"/>
                <a:gd name="T9" fmla="*/ 0 h 2025"/>
                <a:gd name="T10" fmla="*/ 1745 w 1745"/>
                <a:gd name="T11" fmla="*/ 6 h 2025"/>
                <a:gd name="T12" fmla="*/ 1745 w 1745"/>
                <a:gd name="T13" fmla="*/ 2020 h 2025"/>
                <a:gd name="T14" fmla="*/ 1743 w 1745"/>
                <a:gd name="T15" fmla="*/ 2023 h 2025"/>
                <a:gd name="T16" fmla="*/ 1739 w 1745"/>
                <a:gd name="T17" fmla="*/ 2025 h 2025"/>
                <a:gd name="T18" fmla="*/ 6 w 1745"/>
                <a:gd name="T19" fmla="*/ 2025 h 2025"/>
                <a:gd name="T20" fmla="*/ 0 w 1745"/>
                <a:gd name="T21" fmla="*/ 2023 h 2025"/>
                <a:gd name="T22" fmla="*/ 0 w 1745"/>
                <a:gd name="T23" fmla="*/ 2020 h 2025"/>
                <a:gd name="T24" fmla="*/ 0 w 1745"/>
                <a:gd name="T25" fmla="*/ 6 h 2025"/>
                <a:gd name="T26" fmla="*/ 12 w 1745"/>
                <a:gd name="T27" fmla="*/ 2020 h 2025"/>
                <a:gd name="T28" fmla="*/ 6 w 1745"/>
                <a:gd name="T29" fmla="*/ 2014 h 2025"/>
                <a:gd name="T30" fmla="*/ 1739 w 1745"/>
                <a:gd name="T31" fmla="*/ 2014 h 2025"/>
                <a:gd name="T32" fmla="*/ 1734 w 1745"/>
                <a:gd name="T33" fmla="*/ 2020 h 2025"/>
                <a:gd name="T34" fmla="*/ 1734 w 1745"/>
                <a:gd name="T35" fmla="*/ 6 h 2025"/>
                <a:gd name="T36" fmla="*/ 1739 w 1745"/>
                <a:gd name="T37" fmla="*/ 11 h 2025"/>
                <a:gd name="T38" fmla="*/ 6 w 1745"/>
                <a:gd name="T39" fmla="*/ 11 h 2025"/>
                <a:gd name="T40" fmla="*/ 12 w 1745"/>
                <a:gd name="T41" fmla="*/ 6 h 2025"/>
                <a:gd name="T42" fmla="*/ 12 w 1745"/>
                <a:gd name="T43" fmla="*/ 2020 h 20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745" h="2025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739" y="0"/>
                  </a:lnTo>
                  <a:lnTo>
                    <a:pt x="1743" y="0"/>
                  </a:lnTo>
                  <a:lnTo>
                    <a:pt x="1745" y="6"/>
                  </a:lnTo>
                  <a:lnTo>
                    <a:pt x="1745" y="2020"/>
                  </a:lnTo>
                  <a:lnTo>
                    <a:pt x="1743" y="2023"/>
                  </a:lnTo>
                  <a:lnTo>
                    <a:pt x="1739" y="2025"/>
                  </a:lnTo>
                  <a:lnTo>
                    <a:pt x="6" y="2025"/>
                  </a:lnTo>
                  <a:lnTo>
                    <a:pt x="0" y="2023"/>
                  </a:lnTo>
                  <a:lnTo>
                    <a:pt x="0" y="2020"/>
                  </a:lnTo>
                  <a:lnTo>
                    <a:pt x="0" y="6"/>
                  </a:lnTo>
                  <a:close/>
                  <a:moveTo>
                    <a:pt x="12" y="2020"/>
                  </a:moveTo>
                  <a:lnTo>
                    <a:pt x="6" y="2014"/>
                  </a:lnTo>
                  <a:lnTo>
                    <a:pt x="1739" y="2014"/>
                  </a:lnTo>
                  <a:lnTo>
                    <a:pt x="1734" y="2020"/>
                  </a:lnTo>
                  <a:lnTo>
                    <a:pt x="1734" y="6"/>
                  </a:lnTo>
                  <a:lnTo>
                    <a:pt x="1739" y="11"/>
                  </a:lnTo>
                  <a:lnTo>
                    <a:pt x="6" y="11"/>
                  </a:lnTo>
                  <a:lnTo>
                    <a:pt x="12" y="6"/>
                  </a:lnTo>
                  <a:lnTo>
                    <a:pt x="12" y="2020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4" name="Freeform 150"/>
            <p:cNvSpPr>
              <a:spLocks noEditPoints="1"/>
            </p:cNvSpPr>
            <p:nvPr/>
          </p:nvSpPr>
          <p:spPr bwMode="auto">
            <a:xfrm>
              <a:off x="3001963" y="6565901"/>
              <a:ext cx="146050" cy="1387475"/>
            </a:xfrm>
            <a:custGeom>
              <a:avLst/>
              <a:gdLst>
                <a:gd name="T0" fmla="*/ 0 w 184"/>
                <a:gd name="T1" fmla="*/ 6 h 1749"/>
                <a:gd name="T2" fmla="*/ 0 w 184"/>
                <a:gd name="T3" fmla="*/ 0 h 1749"/>
                <a:gd name="T4" fmla="*/ 5 w 184"/>
                <a:gd name="T5" fmla="*/ 0 h 1749"/>
                <a:gd name="T6" fmla="*/ 178 w 184"/>
                <a:gd name="T7" fmla="*/ 0 h 1749"/>
                <a:gd name="T8" fmla="*/ 182 w 184"/>
                <a:gd name="T9" fmla="*/ 0 h 1749"/>
                <a:gd name="T10" fmla="*/ 184 w 184"/>
                <a:gd name="T11" fmla="*/ 6 h 1749"/>
                <a:gd name="T12" fmla="*/ 184 w 184"/>
                <a:gd name="T13" fmla="*/ 1744 h 1749"/>
                <a:gd name="T14" fmla="*/ 182 w 184"/>
                <a:gd name="T15" fmla="*/ 1747 h 1749"/>
                <a:gd name="T16" fmla="*/ 178 w 184"/>
                <a:gd name="T17" fmla="*/ 1749 h 1749"/>
                <a:gd name="T18" fmla="*/ 5 w 184"/>
                <a:gd name="T19" fmla="*/ 1749 h 1749"/>
                <a:gd name="T20" fmla="*/ 0 w 184"/>
                <a:gd name="T21" fmla="*/ 1747 h 1749"/>
                <a:gd name="T22" fmla="*/ 0 w 184"/>
                <a:gd name="T23" fmla="*/ 1744 h 1749"/>
                <a:gd name="T24" fmla="*/ 0 w 184"/>
                <a:gd name="T25" fmla="*/ 6 h 1749"/>
                <a:gd name="T26" fmla="*/ 11 w 184"/>
                <a:gd name="T27" fmla="*/ 1744 h 1749"/>
                <a:gd name="T28" fmla="*/ 5 w 184"/>
                <a:gd name="T29" fmla="*/ 1738 h 1749"/>
                <a:gd name="T30" fmla="*/ 178 w 184"/>
                <a:gd name="T31" fmla="*/ 1738 h 1749"/>
                <a:gd name="T32" fmla="*/ 172 w 184"/>
                <a:gd name="T33" fmla="*/ 1744 h 1749"/>
                <a:gd name="T34" fmla="*/ 172 w 184"/>
                <a:gd name="T35" fmla="*/ 6 h 1749"/>
                <a:gd name="T36" fmla="*/ 178 w 184"/>
                <a:gd name="T37" fmla="*/ 12 h 1749"/>
                <a:gd name="T38" fmla="*/ 5 w 184"/>
                <a:gd name="T39" fmla="*/ 12 h 1749"/>
                <a:gd name="T40" fmla="*/ 11 w 184"/>
                <a:gd name="T41" fmla="*/ 6 h 1749"/>
                <a:gd name="T42" fmla="*/ 11 w 184"/>
                <a:gd name="T43" fmla="*/ 1744 h 17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84" h="1749">
                  <a:moveTo>
                    <a:pt x="0" y="6"/>
                  </a:moveTo>
                  <a:lnTo>
                    <a:pt x="0" y="0"/>
                  </a:lnTo>
                  <a:lnTo>
                    <a:pt x="5" y="0"/>
                  </a:lnTo>
                  <a:lnTo>
                    <a:pt x="178" y="0"/>
                  </a:lnTo>
                  <a:lnTo>
                    <a:pt x="182" y="0"/>
                  </a:lnTo>
                  <a:lnTo>
                    <a:pt x="184" y="6"/>
                  </a:lnTo>
                  <a:lnTo>
                    <a:pt x="184" y="1744"/>
                  </a:lnTo>
                  <a:lnTo>
                    <a:pt x="182" y="1747"/>
                  </a:lnTo>
                  <a:lnTo>
                    <a:pt x="178" y="1749"/>
                  </a:lnTo>
                  <a:lnTo>
                    <a:pt x="5" y="1749"/>
                  </a:lnTo>
                  <a:lnTo>
                    <a:pt x="0" y="1747"/>
                  </a:lnTo>
                  <a:lnTo>
                    <a:pt x="0" y="1744"/>
                  </a:lnTo>
                  <a:lnTo>
                    <a:pt x="0" y="6"/>
                  </a:lnTo>
                  <a:close/>
                  <a:moveTo>
                    <a:pt x="11" y="1744"/>
                  </a:moveTo>
                  <a:lnTo>
                    <a:pt x="5" y="1738"/>
                  </a:lnTo>
                  <a:lnTo>
                    <a:pt x="178" y="1738"/>
                  </a:lnTo>
                  <a:lnTo>
                    <a:pt x="172" y="1744"/>
                  </a:lnTo>
                  <a:lnTo>
                    <a:pt x="172" y="6"/>
                  </a:lnTo>
                  <a:lnTo>
                    <a:pt x="178" y="12"/>
                  </a:lnTo>
                  <a:lnTo>
                    <a:pt x="5" y="12"/>
                  </a:lnTo>
                  <a:lnTo>
                    <a:pt x="11" y="6"/>
                  </a:lnTo>
                  <a:lnTo>
                    <a:pt x="11" y="1744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5" name="Freeform 151"/>
            <p:cNvSpPr>
              <a:spLocks noEditPoints="1"/>
            </p:cNvSpPr>
            <p:nvPr/>
          </p:nvSpPr>
          <p:spPr bwMode="auto">
            <a:xfrm>
              <a:off x="3346451" y="6710363"/>
              <a:ext cx="146050" cy="1243013"/>
            </a:xfrm>
            <a:custGeom>
              <a:avLst/>
              <a:gdLst>
                <a:gd name="T0" fmla="*/ 0 w 184"/>
                <a:gd name="T1" fmla="*/ 5 h 1566"/>
                <a:gd name="T2" fmla="*/ 0 w 184"/>
                <a:gd name="T3" fmla="*/ 0 h 1566"/>
                <a:gd name="T4" fmla="*/ 5 w 184"/>
                <a:gd name="T5" fmla="*/ 0 h 1566"/>
                <a:gd name="T6" fmla="*/ 178 w 184"/>
                <a:gd name="T7" fmla="*/ 0 h 1566"/>
                <a:gd name="T8" fmla="*/ 182 w 184"/>
                <a:gd name="T9" fmla="*/ 0 h 1566"/>
                <a:gd name="T10" fmla="*/ 184 w 184"/>
                <a:gd name="T11" fmla="*/ 5 h 1566"/>
                <a:gd name="T12" fmla="*/ 184 w 184"/>
                <a:gd name="T13" fmla="*/ 1561 h 1566"/>
                <a:gd name="T14" fmla="*/ 182 w 184"/>
                <a:gd name="T15" fmla="*/ 1564 h 1566"/>
                <a:gd name="T16" fmla="*/ 178 w 184"/>
                <a:gd name="T17" fmla="*/ 1566 h 1566"/>
                <a:gd name="T18" fmla="*/ 5 w 184"/>
                <a:gd name="T19" fmla="*/ 1566 h 1566"/>
                <a:gd name="T20" fmla="*/ 0 w 184"/>
                <a:gd name="T21" fmla="*/ 1564 h 1566"/>
                <a:gd name="T22" fmla="*/ 0 w 184"/>
                <a:gd name="T23" fmla="*/ 1561 h 1566"/>
                <a:gd name="T24" fmla="*/ 0 w 184"/>
                <a:gd name="T25" fmla="*/ 5 h 1566"/>
                <a:gd name="T26" fmla="*/ 11 w 184"/>
                <a:gd name="T27" fmla="*/ 1561 h 1566"/>
                <a:gd name="T28" fmla="*/ 5 w 184"/>
                <a:gd name="T29" fmla="*/ 1555 h 1566"/>
                <a:gd name="T30" fmla="*/ 178 w 184"/>
                <a:gd name="T31" fmla="*/ 1555 h 1566"/>
                <a:gd name="T32" fmla="*/ 172 w 184"/>
                <a:gd name="T33" fmla="*/ 1561 h 1566"/>
                <a:gd name="T34" fmla="*/ 172 w 184"/>
                <a:gd name="T35" fmla="*/ 5 h 1566"/>
                <a:gd name="T36" fmla="*/ 178 w 184"/>
                <a:gd name="T37" fmla="*/ 11 h 1566"/>
                <a:gd name="T38" fmla="*/ 5 w 184"/>
                <a:gd name="T39" fmla="*/ 11 h 1566"/>
                <a:gd name="T40" fmla="*/ 11 w 184"/>
                <a:gd name="T41" fmla="*/ 5 h 1566"/>
                <a:gd name="T42" fmla="*/ 11 w 184"/>
                <a:gd name="T43" fmla="*/ 1561 h 15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84" h="1566">
                  <a:moveTo>
                    <a:pt x="0" y="5"/>
                  </a:moveTo>
                  <a:lnTo>
                    <a:pt x="0" y="0"/>
                  </a:lnTo>
                  <a:lnTo>
                    <a:pt x="5" y="0"/>
                  </a:lnTo>
                  <a:lnTo>
                    <a:pt x="178" y="0"/>
                  </a:lnTo>
                  <a:lnTo>
                    <a:pt x="182" y="0"/>
                  </a:lnTo>
                  <a:lnTo>
                    <a:pt x="184" y="5"/>
                  </a:lnTo>
                  <a:lnTo>
                    <a:pt x="184" y="1561"/>
                  </a:lnTo>
                  <a:lnTo>
                    <a:pt x="182" y="1564"/>
                  </a:lnTo>
                  <a:lnTo>
                    <a:pt x="178" y="1566"/>
                  </a:lnTo>
                  <a:lnTo>
                    <a:pt x="5" y="1566"/>
                  </a:lnTo>
                  <a:lnTo>
                    <a:pt x="0" y="1564"/>
                  </a:lnTo>
                  <a:lnTo>
                    <a:pt x="0" y="1561"/>
                  </a:lnTo>
                  <a:lnTo>
                    <a:pt x="0" y="5"/>
                  </a:lnTo>
                  <a:close/>
                  <a:moveTo>
                    <a:pt x="11" y="1561"/>
                  </a:moveTo>
                  <a:lnTo>
                    <a:pt x="5" y="1555"/>
                  </a:lnTo>
                  <a:lnTo>
                    <a:pt x="178" y="1555"/>
                  </a:lnTo>
                  <a:lnTo>
                    <a:pt x="172" y="1561"/>
                  </a:lnTo>
                  <a:lnTo>
                    <a:pt x="172" y="5"/>
                  </a:lnTo>
                  <a:lnTo>
                    <a:pt x="178" y="11"/>
                  </a:lnTo>
                  <a:lnTo>
                    <a:pt x="5" y="11"/>
                  </a:lnTo>
                  <a:lnTo>
                    <a:pt x="11" y="5"/>
                  </a:lnTo>
                  <a:lnTo>
                    <a:pt x="11" y="1561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236" name="Freeform 152"/>
            <p:cNvSpPr>
              <a:spLocks noEditPoints="1"/>
            </p:cNvSpPr>
            <p:nvPr/>
          </p:nvSpPr>
          <p:spPr bwMode="auto">
            <a:xfrm>
              <a:off x="3690938" y="7526338"/>
              <a:ext cx="146050" cy="427038"/>
            </a:xfrm>
            <a:custGeom>
              <a:avLst/>
              <a:gdLst>
                <a:gd name="T0" fmla="*/ 0 w 185"/>
                <a:gd name="T1" fmla="*/ 6 h 537"/>
                <a:gd name="T2" fmla="*/ 0 w 185"/>
                <a:gd name="T3" fmla="*/ 0 h 537"/>
                <a:gd name="T4" fmla="*/ 6 w 185"/>
                <a:gd name="T5" fmla="*/ 0 h 537"/>
                <a:gd name="T6" fmla="*/ 179 w 185"/>
                <a:gd name="T7" fmla="*/ 0 h 537"/>
                <a:gd name="T8" fmla="*/ 183 w 185"/>
                <a:gd name="T9" fmla="*/ 0 h 537"/>
                <a:gd name="T10" fmla="*/ 185 w 185"/>
                <a:gd name="T11" fmla="*/ 6 h 537"/>
                <a:gd name="T12" fmla="*/ 185 w 185"/>
                <a:gd name="T13" fmla="*/ 532 h 537"/>
                <a:gd name="T14" fmla="*/ 183 w 185"/>
                <a:gd name="T15" fmla="*/ 535 h 537"/>
                <a:gd name="T16" fmla="*/ 179 w 185"/>
                <a:gd name="T17" fmla="*/ 537 h 537"/>
                <a:gd name="T18" fmla="*/ 6 w 185"/>
                <a:gd name="T19" fmla="*/ 537 h 537"/>
                <a:gd name="T20" fmla="*/ 0 w 185"/>
                <a:gd name="T21" fmla="*/ 535 h 537"/>
                <a:gd name="T22" fmla="*/ 0 w 185"/>
                <a:gd name="T23" fmla="*/ 532 h 537"/>
                <a:gd name="T24" fmla="*/ 0 w 185"/>
                <a:gd name="T25" fmla="*/ 6 h 537"/>
                <a:gd name="T26" fmla="*/ 12 w 185"/>
                <a:gd name="T27" fmla="*/ 532 h 537"/>
                <a:gd name="T28" fmla="*/ 6 w 185"/>
                <a:gd name="T29" fmla="*/ 526 h 537"/>
                <a:gd name="T30" fmla="*/ 179 w 185"/>
                <a:gd name="T31" fmla="*/ 526 h 537"/>
                <a:gd name="T32" fmla="*/ 173 w 185"/>
                <a:gd name="T33" fmla="*/ 532 h 537"/>
                <a:gd name="T34" fmla="*/ 173 w 185"/>
                <a:gd name="T35" fmla="*/ 6 h 537"/>
                <a:gd name="T36" fmla="*/ 179 w 185"/>
                <a:gd name="T37" fmla="*/ 11 h 537"/>
                <a:gd name="T38" fmla="*/ 6 w 185"/>
                <a:gd name="T39" fmla="*/ 11 h 537"/>
                <a:gd name="T40" fmla="*/ 12 w 185"/>
                <a:gd name="T41" fmla="*/ 6 h 537"/>
                <a:gd name="T42" fmla="*/ 12 w 185"/>
                <a:gd name="T43" fmla="*/ 532 h 5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</a:cxnLst>
              <a:rect l="0" t="0" r="r" b="b"/>
              <a:pathLst>
                <a:path w="185" h="537">
                  <a:moveTo>
                    <a:pt x="0" y="6"/>
                  </a:moveTo>
                  <a:lnTo>
                    <a:pt x="0" y="0"/>
                  </a:lnTo>
                  <a:lnTo>
                    <a:pt x="6" y="0"/>
                  </a:lnTo>
                  <a:lnTo>
                    <a:pt x="179" y="0"/>
                  </a:lnTo>
                  <a:lnTo>
                    <a:pt x="183" y="0"/>
                  </a:lnTo>
                  <a:lnTo>
                    <a:pt x="185" y="6"/>
                  </a:lnTo>
                  <a:lnTo>
                    <a:pt x="185" y="532"/>
                  </a:lnTo>
                  <a:lnTo>
                    <a:pt x="183" y="535"/>
                  </a:lnTo>
                  <a:lnTo>
                    <a:pt x="179" y="537"/>
                  </a:lnTo>
                  <a:lnTo>
                    <a:pt x="6" y="537"/>
                  </a:lnTo>
                  <a:lnTo>
                    <a:pt x="0" y="535"/>
                  </a:lnTo>
                  <a:lnTo>
                    <a:pt x="0" y="532"/>
                  </a:lnTo>
                  <a:lnTo>
                    <a:pt x="0" y="6"/>
                  </a:lnTo>
                  <a:close/>
                  <a:moveTo>
                    <a:pt x="12" y="532"/>
                  </a:moveTo>
                  <a:lnTo>
                    <a:pt x="6" y="526"/>
                  </a:lnTo>
                  <a:lnTo>
                    <a:pt x="179" y="526"/>
                  </a:lnTo>
                  <a:lnTo>
                    <a:pt x="173" y="532"/>
                  </a:lnTo>
                  <a:lnTo>
                    <a:pt x="173" y="6"/>
                  </a:lnTo>
                  <a:lnTo>
                    <a:pt x="179" y="11"/>
                  </a:lnTo>
                  <a:lnTo>
                    <a:pt x="6" y="11"/>
                  </a:lnTo>
                  <a:lnTo>
                    <a:pt x="12" y="6"/>
                  </a:lnTo>
                  <a:lnTo>
                    <a:pt x="12" y="532"/>
                  </a:lnTo>
                  <a:close/>
                </a:path>
              </a:pathLst>
            </a:custGeom>
            <a:solidFill>
              <a:srgbClr val="000000"/>
            </a:solidFill>
            <a:ln w="1588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</p:grpSp>
      <p:grpSp>
        <p:nvGrpSpPr>
          <p:cNvPr id="237" name="グループ化 236"/>
          <p:cNvGrpSpPr/>
          <p:nvPr/>
        </p:nvGrpSpPr>
        <p:grpSpPr>
          <a:xfrm>
            <a:off x="4540672" y="6512668"/>
            <a:ext cx="256480" cy="1895958"/>
            <a:chOff x="4540672" y="3104542"/>
            <a:chExt cx="256480" cy="1895958"/>
          </a:xfrm>
        </p:grpSpPr>
        <p:sp>
          <p:nvSpPr>
            <p:cNvPr id="238" name="Rectangle 158"/>
            <p:cNvSpPr>
              <a:spLocks noChangeArrowheads="1"/>
            </p:cNvSpPr>
            <p:nvPr/>
          </p:nvSpPr>
          <p:spPr bwMode="auto">
            <a:xfrm>
              <a:off x="4733032" y="4846612"/>
              <a:ext cx="6412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9" name="Rectangle 159"/>
            <p:cNvSpPr>
              <a:spLocks noChangeArrowheads="1"/>
            </p:cNvSpPr>
            <p:nvPr/>
          </p:nvSpPr>
          <p:spPr bwMode="auto">
            <a:xfrm>
              <a:off x="4604792" y="4597744"/>
              <a:ext cx="19236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5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0" name="Rectangle 160"/>
            <p:cNvSpPr>
              <a:spLocks noChangeArrowheads="1"/>
            </p:cNvSpPr>
            <p:nvPr/>
          </p:nvSpPr>
          <p:spPr bwMode="auto">
            <a:xfrm>
              <a:off x="4540672" y="4348877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1" name="Rectangle 161"/>
            <p:cNvSpPr>
              <a:spLocks noChangeArrowheads="1"/>
            </p:cNvSpPr>
            <p:nvPr/>
          </p:nvSpPr>
          <p:spPr bwMode="auto">
            <a:xfrm>
              <a:off x="4540672" y="4100010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15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2" name="Rectangle 162"/>
            <p:cNvSpPr>
              <a:spLocks noChangeArrowheads="1"/>
            </p:cNvSpPr>
            <p:nvPr/>
          </p:nvSpPr>
          <p:spPr bwMode="auto">
            <a:xfrm>
              <a:off x="4540672" y="3851143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3" name="Rectangle 163"/>
            <p:cNvSpPr>
              <a:spLocks noChangeArrowheads="1"/>
            </p:cNvSpPr>
            <p:nvPr/>
          </p:nvSpPr>
          <p:spPr bwMode="auto">
            <a:xfrm>
              <a:off x="4540672" y="3602276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25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4" name="Rectangle 164"/>
            <p:cNvSpPr>
              <a:spLocks noChangeArrowheads="1"/>
            </p:cNvSpPr>
            <p:nvPr/>
          </p:nvSpPr>
          <p:spPr bwMode="auto">
            <a:xfrm>
              <a:off x="4540672" y="3353409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0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5" name="Rectangle 165"/>
            <p:cNvSpPr>
              <a:spLocks noChangeArrowheads="1"/>
            </p:cNvSpPr>
            <p:nvPr/>
          </p:nvSpPr>
          <p:spPr bwMode="auto">
            <a:xfrm>
              <a:off x="4540672" y="3104542"/>
              <a:ext cx="25648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1" lang="ja-JP" altLang="ja-JP" sz="10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rPr>
                <a:t>3500</a:t>
              </a:r>
              <a:endParaRPr kumimoji="1" lang="ja-JP" altLang="ja-JP" sz="18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48" name="テキスト ボックス 247"/>
          <p:cNvSpPr txBox="1"/>
          <p:nvPr/>
        </p:nvSpPr>
        <p:spPr>
          <a:xfrm>
            <a:off x="0" y="0"/>
            <a:ext cx="36210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kumimoji="1" lang="en-US" altLang="ja-JP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99998" y="1105328"/>
            <a:ext cx="4210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 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テキスト ボックス 123"/>
          <p:cNvSpPr txBox="1"/>
          <p:nvPr/>
        </p:nvSpPr>
        <p:spPr>
          <a:xfrm>
            <a:off x="304338" y="5766574"/>
            <a:ext cx="42101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kumimoji="1" lang="en-US" altLang="ja-JP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kumimoji="1" lang="ja-JP" alt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4260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48</TotalTime>
  <Words>102</Words>
  <Application>Microsoft Office PowerPoint</Application>
  <PresentationFormat>A4 210 x 297 mm</PresentationFormat>
  <Paragraphs>7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owner</cp:lastModifiedBy>
  <cp:revision>47</cp:revision>
  <dcterms:created xsi:type="dcterms:W3CDTF">2014-04-14T02:20:34Z</dcterms:created>
  <dcterms:modified xsi:type="dcterms:W3CDTF">2014-10-21T14:32:18Z</dcterms:modified>
</cp:coreProperties>
</file>